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>
    <p:restoredLeft sz="15620"/>
    <p:restoredTop sz="99645" autoAdjust="0"/>
  </p:normalViewPr>
  <p:slideViewPr>
    <p:cSldViewPr>
      <p:cViewPr>
        <p:scale>
          <a:sx n="40" d="100"/>
          <a:sy n="40" d="100"/>
        </p:scale>
        <p:origin x="2736" y="248"/>
      </p:cViewPr>
      <p:guideLst>
        <p:guide orient="horz" pos="2880"/>
        <p:guide pos="2160"/>
      </p:guideLst>
    </p:cSldViewPr>
  </p:slideViewPr>
  <p:notesTextViewPr>
    <p:cViewPr>
      <p:scale>
        <a:sx n="3" d="2"/>
        <a:sy n="3" d="2"/>
      </p:scale>
      <p:origin x="0" y="0"/>
    </p:cViewPr>
  </p:notesTextViewPr>
  <p:sorterViewPr>
    <p:cViewPr>
      <p:scale>
        <a:sx n="104" d="100"/>
        <a:sy n="104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ebastien pirotte" userId="ecff0c4de2a699be" providerId="LiveId" clId="{5735B833-6EF1-426E-B0CB-3610C5FE48EE}"/>
    <pc:docChg chg="undo custSel modSld">
      <pc:chgData name="Sebastien pirotte" userId="ecff0c4de2a699be" providerId="LiveId" clId="{5735B833-6EF1-426E-B0CB-3610C5FE48EE}" dt="2021-06-07T10:01:42.466" v="22" actId="20577"/>
      <pc:docMkLst>
        <pc:docMk/>
      </pc:docMkLst>
      <pc:sldChg chg="modSp mod">
        <pc:chgData name="Sebastien pirotte" userId="ecff0c4de2a699be" providerId="LiveId" clId="{5735B833-6EF1-426E-B0CB-3610C5FE48EE}" dt="2021-06-07T10:01:42.466" v="22" actId="20577"/>
        <pc:sldMkLst>
          <pc:docMk/>
          <pc:sldMk cId="752682250" sldId="257"/>
        </pc:sldMkLst>
        <pc:spChg chg="mod">
          <ac:chgData name="Sebastien pirotte" userId="ecff0c4de2a699be" providerId="LiveId" clId="{5735B833-6EF1-426E-B0CB-3610C5FE48EE}" dt="2021-06-06T19:27:43.076" v="1" actId="465"/>
          <ac:spMkLst>
            <pc:docMk/>
            <pc:sldMk cId="752682250" sldId="257"/>
            <ac:spMk id="318" creationId="{91395F10-CAFB-47FB-86C9-A850B197155A}"/>
          </ac:spMkLst>
        </pc:spChg>
        <pc:spChg chg="mod">
          <ac:chgData name="Sebastien pirotte" userId="ecff0c4de2a699be" providerId="LiveId" clId="{5735B833-6EF1-426E-B0CB-3610C5FE48EE}" dt="2021-06-06T19:27:43.076" v="1" actId="465"/>
          <ac:spMkLst>
            <pc:docMk/>
            <pc:sldMk cId="752682250" sldId="257"/>
            <ac:spMk id="322" creationId="{51E2A2F4-3AAD-4FB7-B615-D177FACB2519}"/>
          </ac:spMkLst>
        </pc:spChg>
        <pc:spChg chg="mod">
          <ac:chgData name="Sebastien pirotte" userId="ecff0c4de2a699be" providerId="LiveId" clId="{5735B833-6EF1-426E-B0CB-3610C5FE48EE}" dt="2021-06-07T10:01:42.466" v="22" actId="20577"/>
          <ac:spMkLst>
            <pc:docMk/>
            <pc:sldMk cId="752682250" sldId="257"/>
            <ac:spMk id="324" creationId="{7273D055-AE1E-4739-8D52-E9D605EEA993}"/>
          </ac:spMkLst>
        </pc:spChg>
        <pc:spChg chg="mod">
          <ac:chgData name="Sebastien pirotte" userId="ecff0c4de2a699be" providerId="LiveId" clId="{5735B833-6EF1-426E-B0CB-3610C5FE48EE}" dt="2021-06-06T19:27:43.076" v="1" actId="465"/>
          <ac:spMkLst>
            <pc:docMk/>
            <pc:sldMk cId="752682250" sldId="257"/>
            <ac:spMk id="326" creationId="{D39B6445-7E20-4298-8712-6CF10E42E19B}"/>
          </ac:spMkLst>
        </pc:spChg>
        <pc:spChg chg="mod">
          <ac:chgData name="Sebastien pirotte" userId="ecff0c4de2a699be" providerId="LiveId" clId="{5735B833-6EF1-426E-B0CB-3610C5FE48EE}" dt="2021-06-06T19:28:28.330" v="3" actId="1076"/>
          <ac:spMkLst>
            <pc:docMk/>
            <pc:sldMk cId="752682250" sldId="257"/>
            <ac:spMk id="331" creationId="{483D35D4-C443-475B-B861-E8C43B289260}"/>
          </ac:spMkLst>
        </pc:spChg>
        <pc:spChg chg="mod">
          <ac:chgData name="Sebastien pirotte" userId="ecff0c4de2a699be" providerId="LiveId" clId="{5735B833-6EF1-426E-B0CB-3610C5FE48EE}" dt="2021-06-07T10:01:13.282" v="13" actId="313"/>
          <ac:spMkLst>
            <pc:docMk/>
            <pc:sldMk cId="752682250" sldId="257"/>
            <ac:spMk id="335" creationId="{AFBF1F5B-A7E1-48F9-BC0A-5FCF7892B0E6}"/>
          </ac:spMkLst>
        </pc:spChg>
        <pc:spChg chg="mod">
          <ac:chgData name="Sebastien pirotte" userId="ecff0c4de2a699be" providerId="LiveId" clId="{5735B833-6EF1-426E-B0CB-3610C5FE48EE}" dt="2021-06-06T19:28:17.818" v="2" actId="1076"/>
          <ac:spMkLst>
            <pc:docMk/>
            <pc:sldMk cId="752682250" sldId="257"/>
            <ac:spMk id="337" creationId="{DCE492EF-6ACE-4FA1-B108-D345D23F5B30}"/>
          </ac:spMkLst>
        </pc:spChg>
        <pc:spChg chg="mod">
          <ac:chgData name="Sebastien pirotte" userId="ecff0c4de2a699be" providerId="LiveId" clId="{5735B833-6EF1-426E-B0CB-3610C5FE48EE}" dt="2021-06-06T19:28:35.875" v="4" actId="1076"/>
          <ac:spMkLst>
            <pc:docMk/>
            <pc:sldMk cId="752682250" sldId="257"/>
            <ac:spMk id="338" creationId="{80EF1314-175D-4CB8-B52F-9C2B707EC625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z le style des sous-titres du masque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54B67F-3E3D-492E-94FF-761B8CF654D6}" type="datetimeFigureOut">
              <a:rPr lang="en-GB" smtClean="0"/>
              <a:t>05/07/2022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FA4234-9448-485F-933A-68A560D0C5BF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353038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54B67F-3E3D-492E-94FF-761B8CF654D6}" type="datetimeFigureOut">
              <a:rPr lang="en-GB" smtClean="0"/>
              <a:t>05/07/2022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FA4234-9448-485F-933A-68A560D0C5BF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637003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54B67F-3E3D-492E-94FF-761B8CF654D6}" type="datetimeFigureOut">
              <a:rPr lang="en-GB" smtClean="0"/>
              <a:t>05/07/2022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FA4234-9448-485F-933A-68A560D0C5BF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712921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54B67F-3E3D-492E-94FF-761B8CF654D6}" type="datetimeFigureOut">
              <a:rPr lang="en-GB" smtClean="0"/>
              <a:t>05/07/2022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FA4234-9448-485F-933A-68A560D0C5BF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155138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54B67F-3E3D-492E-94FF-761B8CF654D6}" type="datetimeFigureOut">
              <a:rPr lang="en-GB" smtClean="0"/>
              <a:t>05/07/2022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FA4234-9448-485F-933A-68A560D0C5BF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788292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54B67F-3E3D-492E-94FF-761B8CF654D6}" type="datetimeFigureOut">
              <a:rPr lang="en-GB" smtClean="0"/>
              <a:t>05/07/2022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FA4234-9448-485F-933A-68A560D0C5BF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852021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54B67F-3E3D-492E-94FF-761B8CF654D6}" type="datetimeFigureOut">
              <a:rPr lang="en-GB" smtClean="0"/>
              <a:t>05/07/2022</a:t>
            </a:fld>
            <a:endParaRPr lang="en-GB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FA4234-9448-485F-933A-68A560D0C5BF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051660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54B67F-3E3D-492E-94FF-761B8CF654D6}" type="datetimeFigureOut">
              <a:rPr lang="en-GB" smtClean="0"/>
              <a:t>05/07/2022</a:t>
            </a:fld>
            <a:endParaRPr lang="en-GB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FA4234-9448-485F-933A-68A560D0C5BF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079633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54B67F-3E3D-492E-94FF-761B8CF654D6}" type="datetimeFigureOut">
              <a:rPr lang="en-GB" smtClean="0"/>
              <a:t>05/07/2022</a:t>
            </a:fld>
            <a:endParaRPr lang="en-GB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FA4234-9448-485F-933A-68A560D0C5BF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096369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54B67F-3E3D-492E-94FF-761B8CF654D6}" type="datetimeFigureOut">
              <a:rPr lang="en-GB" smtClean="0"/>
              <a:t>05/07/2022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FA4234-9448-485F-933A-68A560D0C5BF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570001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54B67F-3E3D-492E-94FF-761B8CF654D6}" type="datetimeFigureOut">
              <a:rPr lang="en-GB" smtClean="0"/>
              <a:t>05/07/2022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FA4234-9448-485F-933A-68A560D0C5BF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532042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54B67F-3E3D-492E-94FF-761B8CF654D6}" type="datetimeFigureOut">
              <a:rPr lang="en-GB" smtClean="0"/>
              <a:t>05/07/2022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FA4234-9448-485F-933A-68A560D0C5BF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018165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image" Target="../media/image9.tiff"/><Relationship Id="rId18" Type="http://schemas.openxmlformats.org/officeDocument/2006/relationships/image" Target="../media/image13.png"/><Relationship Id="rId26" Type="http://schemas.microsoft.com/office/2007/relationships/hdphoto" Target="../media/hdphoto7.wdp"/><Relationship Id="rId39" Type="http://schemas.openxmlformats.org/officeDocument/2006/relationships/image" Target="../media/image28.tiff"/><Relationship Id="rId21" Type="http://schemas.openxmlformats.org/officeDocument/2006/relationships/image" Target="../media/image15.tiff"/><Relationship Id="rId34" Type="http://schemas.microsoft.com/office/2007/relationships/hdphoto" Target="../media/hdphoto9.wdp"/><Relationship Id="rId42" Type="http://schemas.microsoft.com/office/2007/relationships/hdphoto" Target="../media/hdphoto11.wdp"/><Relationship Id="rId7" Type="http://schemas.openxmlformats.org/officeDocument/2006/relationships/image" Target="../media/image5.png"/><Relationship Id="rId2" Type="http://schemas.openxmlformats.org/officeDocument/2006/relationships/image" Target="../media/image1.png"/><Relationship Id="rId16" Type="http://schemas.microsoft.com/office/2007/relationships/hdphoto" Target="../media/hdphoto4.wdp"/><Relationship Id="rId20" Type="http://schemas.openxmlformats.org/officeDocument/2006/relationships/image" Target="../media/image14.tiff"/><Relationship Id="rId29" Type="http://schemas.openxmlformats.org/officeDocument/2006/relationships/image" Target="../media/image21.tiff"/><Relationship Id="rId41" Type="http://schemas.openxmlformats.org/officeDocument/2006/relationships/image" Target="../media/image3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tiff"/><Relationship Id="rId11" Type="http://schemas.openxmlformats.org/officeDocument/2006/relationships/image" Target="../media/image7.tiff"/><Relationship Id="rId24" Type="http://schemas.openxmlformats.org/officeDocument/2006/relationships/image" Target="../media/image17.tiff"/><Relationship Id="rId32" Type="http://schemas.microsoft.com/office/2007/relationships/hdphoto" Target="../media/hdphoto8.wdp"/><Relationship Id="rId37" Type="http://schemas.openxmlformats.org/officeDocument/2006/relationships/image" Target="../media/image27.png"/><Relationship Id="rId40" Type="http://schemas.openxmlformats.org/officeDocument/2006/relationships/image" Target="../media/image29.tiff"/><Relationship Id="rId5" Type="http://schemas.openxmlformats.org/officeDocument/2006/relationships/image" Target="../media/image3.tiff"/><Relationship Id="rId15" Type="http://schemas.openxmlformats.org/officeDocument/2006/relationships/image" Target="../media/image11.png"/><Relationship Id="rId23" Type="http://schemas.microsoft.com/office/2007/relationships/hdphoto" Target="../media/hdphoto6.wdp"/><Relationship Id="rId28" Type="http://schemas.openxmlformats.org/officeDocument/2006/relationships/image" Target="../media/image20.tiff"/><Relationship Id="rId36" Type="http://schemas.openxmlformats.org/officeDocument/2006/relationships/image" Target="../media/image26.jpeg"/><Relationship Id="rId10" Type="http://schemas.microsoft.com/office/2007/relationships/hdphoto" Target="../media/hdphoto3.wdp"/><Relationship Id="rId19" Type="http://schemas.microsoft.com/office/2007/relationships/hdphoto" Target="../media/hdphoto5.wdp"/><Relationship Id="rId31" Type="http://schemas.openxmlformats.org/officeDocument/2006/relationships/image" Target="../media/image23.png"/><Relationship Id="rId4" Type="http://schemas.openxmlformats.org/officeDocument/2006/relationships/image" Target="../media/image2.tiff"/><Relationship Id="rId9" Type="http://schemas.openxmlformats.org/officeDocument/2006/relationships/image" Target="../media/image6.png"/><Relationship Id="rId14" Type="http://schemas.openxmlformats.org/officeDocument/2006/relationships/image" Target="../media/image10.tiff"/><Relationship Id="rId22" Type="http://schemas.openxmlformats.org/officeDocument/2006/relationships/image" Target="../media/image16.png"/><Relationship Id="rId27" Type="http://schemas.openxmlformats.org/officeDocument/2006/relationships/image" Target="../media/image19.tiff"/><Relationship Id="rId30" Type="http://schemas.openxmlformats.org/officeDocument/2006/relationships/image" Target="../media/image22.tiff"/><Relationship Id="rId35" Type="http://schemas.openxmlformats.org/officeDocument/2006/relationships/image" Target="../media/image25.jpeg"/><Relationship Id="rId43" Type="http://schemas.openxmlformats.org/officeDocument/2006/relationships/image" Target="../media/image31.tiff"/><Relationship Id="rId8" Type="http://schemas.microsoft.com/office/2007/relationships/hdphoto" Target="../media/hdphoto2.wdp"/><Relationship Id="rId3" Type="http://schemas.microsoft.com/office/2007/relationships/hdphoto" Target="../media/hdphoto1.wdp"/><Relationship Id="rId12" Type="http://schemas.openxmlformats.org/officeDocument/2006/relationships/image" Target="../media/image8.tiff"/><Relationship Id="rId17" Type="http://schemas.openxmlformats.org/officeDocument/2006/relationships/image" Target="../media/image12.tiff"/><Relationship Id="rId25" Type="http://schemas.openxmlformats.org/officeDocument/2006/relationships/image" Target="../media/image18.png"/><Relationship Id="rId33" Type="http://schemas.openxmlformats.org/officeDocument/2006/relationships/image" Target="../media/image24.png"/><Relationship Id="rId38" Type="http://schemas.microsoft.com/office/2007/relationships/hdphoto" Target="../media/hdphoto10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>
            <a:extLst>
              <a:ext uri="{FF2B5EF4-FFF2-40B4-BE49-F238E27FC236}">
                <a16:creationId xmlns:a16="http://schemas.microsoft.com/office/drawing/2014/main" id="{F47E25BF-6A75-4BD3-8215-A29706C46DB6}"/>
              </a:ext>
            </a:extLst>
          </p:cNvPr>
          <p:cNvGrpSpPr/>
          <p:nvPr/>
        </p:nvGrpSpPr>
        <p:grpSpPr>
          <a:xfrm>
            <a:off x="383235" y="835968"/>
            <a:ext cx="5998093" cy="7624464"/>
            <a:chOff x="332656" y="475928"/>
            <a:chExt cx="5998093" cy="7624464"/>
          </a:xfrm>
        </p:grpSpPr>
        <p:grpSp>
          <p:nvGrpSpPr>
            <p:cNvPr id="142" name="Groupe 141"/>
            <p:cNvGrpSpPr/>
            <p:nvPr/>
          </p:nvGrpSpPr>
          <p:grpSpPr>
            <a:xfrm>
              <a:off x="332656" y="475928"/>
              <a:ext cx="5998093" cy="7624464"/>
              <a:chOff x="332656" y="475928"/>
              <a:chExt cx="5998093" cy="7624464"/>
            </a:xfrm>
          </p:grpSpPr>
          <p:cxnSp>
            <p:nvCxnSpPr>
              <p:cNvPr id="319" name="Connecteur droit avec flèche 318"/>
              <p:cNvCxnSpPr/>
              <p:nvPr/>
            </p:nvCxnSpPr>
            <p:spPr>
              <a:xfrm flipH="1">
                <a:off x="3856247" y="3027675"/>
                <a:ext cx="1059503" cy="632004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prstDash val="sysDot"/>
                <a:headEnd type="none" w="med" len="med"/>
                <a:tailEnd type="non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1" name="Connecteur droit avec flèche 320"/>
              <p:cNvCxnSpPr/>
              <p:nvPr/>
            </p:nvCxnSpPr>
            <p:spPr>
              <a:xfrm>
                <a:off x="5425610" y="3036011"/>
                <a:ext cx="88900" cy="617501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prstDash val="sysDot"/>
                <a:headEnd type="none" w="med" len="med"/>
                <a:tailEnd type="non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6" name="Connecteur droit avec flèche 315"/>
              <p:cNvCxnSpPr/>
              <p:nvPr/>
            </p:nvCxnSpPr>
            <p:spPr>
              <a:xfrm flipH="1">
                <a:off x="2181600" y="3036011"/>
                <a:ext cx="637235" cy="641567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prstDash val="sysDot"/>
                <a:headEnd type="none" w="med" len="med"/>
                <a:tailEnd type="non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4" name="Groupe 3"/>
              <p:cNvGrpSpPr/>
              <p:nvPr/>
            </p:nvGrpSpPr>
            <p:grpSpPr>
              <a:xfrm>
                <a:off x="332656" y="3262372"/>
                <a:ext cx="5998093" cy="4838020"/>
                <a:chOff x="206457" y="3487688"/>
                <a:chExt cx="5998093" cy="4838020"/>
              </a:xfrm>
            </p:grpSpPr>
            <p:sp>
              <p:nvSpPr>
                <p:cNvPr id="5" name="ZoneTexte 4"/>
                <p:cNvSpPr txBox="1"/>
                <p:nvPr/>
              </p:nvSpPr>
              <p:spPr>
                <a:xfrm>
                  <a:off x="206457" y="3487688"/>
                  <a:ext cx="936104" cy="400110"/>
                </a:xfrm>
                <a:prstGeom prst="rect">
                  <a:avLst/>
                </a:prstGeom>
                <a:noFill/>
                <a:ln w="28575"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fr-BE" sz="2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</a:t>
                  </a:r>
                </a:p>
              </p:txBody>
            </p:sp>
            <p:sp>
              <p:nvSpPr>
                <p:cNvPr id="6" name="ZoneTexte 5"/>
                <p:cNvSpPr txBox="1"/>
                <p:nvPr/>
              </p:nvSpPr>
              <p:spPr>
                <a:xfrm rot="18147718">
                  <a:off x="320834" y="4019688"/>
                  <a:ext cx="1224136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fr-BE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ORF112</a:t>
                  </a:r>
                  <a:endParaRPr lang="en-GB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" name="ZoneTexte 6"/>
                <p:cNvSpPr txBox="1"/>
                <p:nvPr/>
              </p:nvSpPr>
              <p:spPr>
                <a:xfrm rot="18147718">
                  <a:off x="603004" y="4019688"/>
                  <a:ext cx="1224136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fr-BE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ORF149</a:t>
                  </a:r>
                  <a:endParaRPr lang="en-GB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" name="ZoneTexte 7"/>
                <p:cNvSpPr txBox="1"/>
                <p:nvPr/>
              </p:nvSpPr>
              <p:spPr>
                <a:xfrm>
                  <a:off x="720111" y="4691381"/>
                  <a:ext cx="22185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fr-BE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  <a:endParaRPr lang="en-GB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" name="ZoneTexte 8"/>
                <p:cNvSpPr txBox="1"/>
                <p:nvPr/>
              </p:nvSpPr>
              <p:spPr>
                <a:xfrm>
                  <a:off x="718975" y="5933510"/>
                  <a:ext cx="22185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fr-BE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  <a:endParaRPr lang="en-GB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" name="ZoneTexte 9"/>
                <p:cNvSpPr txBox="1"/>
                <p:nvPr/>
              </p:nvSpPr>
              <p:spPr>
                <a:xfrm>
                  <a:off x="718497" y="7160358"/>
                  <a:ext cx="22185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fr-BE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  <a:endParaRPr lang="en-GB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" name="ZoneTexte 10"/>
                <p:cNvSpPr txBox="1"/>
                <p:nvPr/>
              </p:nvSpPr>
              <p:spPr>
                <a:xfrm>
                  <a:off x="720193" y="7956376"/>
                  <a:ext cx="22185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fr-BE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  <a:endParaRPr lang="en-GB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" name="ZoneTexte 11"/>
                <p:cNvSpPr txBox="1"/>
                <p:nvPr/>
              </p:nvSpPr>
              <p:spPr>
                <a:xfrm>
                  <a:off x="997677" y="4691381"/>
                  <a:ext cx="22185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fr-BE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  <a:endParaRPr lang="en-GB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" name="ZoneTexte 12"/>
                <p:cNvSpPr txBox="1"/>
                <p:nvPr/>
              </p:nvSpPr>
              <p:spPr>
                <a:xfrm>
                  <a:off x="996541" y="5912345"/>
                  <a:ext cx="22185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fr-BE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  <a:endParaRPr lang="en-GB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" name="ZoneTexte 13"/>
                <p:cNvSpPr txBox="1"/>
                <p:nvPr/>
              </p:nvSpPr>
              <p:spPr>
                <a:xfrm>
                  <a:off x="996063" y="7181523"/>
                  <a:ext cx="22185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fr-BE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</a:t>
                  </a:r>
                  <a:endParaRPr lang="en-GB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" name="ZoneTexte 14"/>
                <p:cNvSpPr txBox="1"/>
                <p:nvPr/>
              </p:nvSpPr>
              <p:spPr>
                <a:xfrm>
                  <a:off x="997759" y="7956376"/>
                  <a:ext cx="221852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fr-BE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  <a:endParaRPr lang="en-GB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pic>
              <p:nvPicPr>
                <p:cNvPr id="16" name="Picture 3" descr="C:\Users\u218433\Documents\documents\data\microscope images\leica sp5\112 149 ESSENTIALITY EXPERIMENT\C4-ESSENTIALITY 112-149 EXPERIMENT 48h PT.lif - 112-149+ and 112+149- Zoom 1 ORF112.tif"/>
                <p:cNvPicPr>
                  <a:picLocks noChangeAspect="1" noChangeArrowheads="1"/>
                </p:cNvPicPr>
                <p:nvPr/>
              </p:nvPicPr>
              <p:blipFill>
                <a:blip r:embed="rId2" cstate="print">
                  <a:extLst>
                    <a:ext uri="{BEBA8EAE-BF5A-486C-A8C5-ECC9F3942E4B}">
                      <a14:imgProps xmlns:a14="http://schemas.microsoft.com/office/drawing/2010/main">
                        <a14:imgLayer r:embed="rId3">
                          <a14:imgEffect>
                            <a14:brightnessContrast bright="40000" contrast="-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1338752" y="4283968"/>
                  <a:ext cx="718383" cy="590719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17" name="Picture 4" descr="C:\Users\u218433\Documents\documents\data\microscope images\leica sp5\112 149 ESSENTIALITY EXPERIMENT\C3-ESSENTIALITY 112-149 EXPERIMENT 48h PT.lif - 112-149+ and 112+149- Zoom 1 orf149.tif"/>
                <p:cNvPicPr>
                  <a:picLocks noChangeAspect="1" noChangeArrowheads="1"/>
                </p:cNvPicPr>
                <p:nvPr/>
              </p:nvPicPr>
              <p:blipFill>
                <a:blip r:embed="rId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2079300" y="4282516"/>
                  <a:ext cx="718383" cy="5904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18" name="Picture 2" descr="C:\Users\u218433\Documents\documents\data\microscope images\leica sp5\112 149 ESSENTIALITY EXPERIMENT\C2-ESSENTIALITY 112-149 EXPERIMENT 48h PT.lif - 112-149+ and 112+149- Zoom 1 BAC.tif"/>
                <p:cNvPicPr>
                  <a:picLocks noChangeAspect="1" noChangeArrowheads="1"/>
                </p:cNvPicPr>
                <p:nvPr/>
              </p:nvPicPr>
              <p:blipFill>
                <a:blip r:embed="rId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1338752" y="4892942"/>
                  <a:ext cx="718383" cy="5904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19" name="Picture 5" descr="C:\Users\u218433\Documents\documents\data\microscope images\leica sp5\112 149 ESSENTIALITY EXPERIMENT\ESSENTIALITY 112-149 EXPERIMENT 48h PT.lif - 112-149+ and 112+149- Zoom 1 ++ OVERLAY.tif"/>
                <p:cNvPicPr>
                  <a:picLocks noChangeAspect="1" noChangeArrowheads="1"/>
                </p:cNvPicPr>
                <p:nvPr/>
              </p:nvPicPr>
              <p:blipFill>
                <a:blip r:embed="rId6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2079300" y="4892799"/>
                  <a:ext cx="718871" cy="5904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sp>
              <p:nvSpPr>
                <p:cNvPr id="20" name="ZoneTexte 19"/>
                <p:cNvSpPr txBox="1"/>
                <p:nvPr/>
              </p:nvSpPr>
              <p:spPr>
                <a:xfrm>
                  <a:off x="1324913" y="8019078"/>
                  <a:ext cx="148528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en-US"/>
                  </a:defPPr>
                  <a:lvl1pPr algn="ctr">
                    <a:defRPr sz="1200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fr-BE" dirty="0"/>
                    <a:t>Not applicable</a:t>
                  </a:r>
                  <a:endParaRPr lang="en-GB" dirty="0"/>
                </a:p>
              </p:txBody>
            </p:sp>
            <p:sp>
              <p:nvSpPr>
                <p:cNvPr id="21" name="ZoneTexte 20"/>
                <p:cNvSpPr txBox="1"/>
                <p:nvPr/>
              </p:nvSpPr>
              <p:spPr>
                <a:xfrm>
                  <a:off x="4649261" y="7228333"/>
                  <a:ext cx="148528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fr-BE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ot </a:t>
                  </a:r>
                  <a:r>
                    <a:rPr lang="fr-BE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detected</a:t>
                  </a:r>
                  <a:endParaRPr lang="en-GB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pic>
              <p:nvPicPr>
                <p:cNvPr id="22" name="Picture 14" descr="C:\Users\u218433\Documents\Documents\Data\Microscope images\Leica SP5\112 149 ESSENTIALITY EXPERIMENT\48 hours post-transfection\C2-ESSENTIALITY 112-149 EXPERIMENT all times.lif - 112+149- - Zoom 3 VIRUS.tif"/>
                <p:cNvPicPr>
                  <a:picLocks noChangeAspect="1" noChangeArrowheads="1"/>
                </p:cNvPicPr>
                <p:nvPr/>
              </p:nvPicPr>
              <p:blipFill>
                <a:blip r:embed="rId7" cstate="print">
                  <a:extLst>
                    <a:ext uri="{BEBA8EAE-BF5A-486C-A8C5-ECC9F3942E4B}">
                      <a14:imgProps xmlns:a14="http://schemas.microsoft.com/office/drawing/2010/main">
                        <a14:imgLayer r:embed="rId8">
                          <a14:imgEffect>
                            <a14:brightnessContrast bright="40000" contrast="-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1337699" y="6136502"/>
                  <a:ext cx="718383" cy="5904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23" name="Picture 15" descr="C:\Users\u218433\Documents\Documents\Data\Microscope images\Leica SP5\112 149 ESSENTIALITY EXPERIMENT\48 hours post-transfection\C3-ESSENTIALITY 112-149 EXPERIMENT all times.lif - 112+149- - Zoom 3 ORF112.tif"/>
                <p:cNvPicPr>
                  <a:picLocks noChangeAspect="1" noChangeArrowheads="1"/>
                </p:cNvPicPr>
                <p:nvPr/>
              </p:nvPicPr>
              <p:blipFill>
                <a:blip r:embed="rId9" cstate="print">
                  <a:extLst>
                    <a:ext uri="{BEBA8EAE-BF5A-486C-A8C5-ECC9F3942E4B}">
                      <a14:imgProps xmlns:a14="http://schemas.microsoft.com/office/drawing/2010/main">
                        <a14:imgLayer r:embed="rId10">
                          <a14:imgEffect>
                            <a14:brightnessContrast bright="40000" contrast="-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1339001" y="5527847"/>
                  <a:ext cx="721308" cy="5904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24" name="Picture 16" descr="C:\Users\u218433\Documents\Documents\Data\Microscope images\Leica SP5\112 149 ESSENTIALITY EXPERIMENT\48 hours post-transfection\C4-ESSENTIALITY 112-149 EXPERIMENT all times.lif - 112+149- - Zoom 3 ORF149.tif"/>
                <p:cNvPicPr>
                  <a:picLocks noChangeAspect="1" noChangeArrowheads="1"/>
                </p:cNvPicPr>
                <p:nvPr/>
              </p:nvPicPr>
              <p:blipFill>
                <a:blip r:embed="rId11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2079894" y="5527847"/>
                  <a:ext cx="718871" cy="5904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25" name="Picture 12" descr="C:\Users\u218433\Documents\Documents\Data\Microscope images\Leica SP5\112 149 ESSENTIALITY EXPERIMENT\48 hours post-transfection\ESSENTIALITY 112-149 EXPERIMENT all times.lif - 112+149- - Zoom 3 OVERLAY.tif"/>
                <p:cNvPicPr>
                  <a:picLocks noChangeAspect="1" noChangeArrowheads="1"/>
                </p:cNvPicPr>
                <p:nvPr/>
              </p:nvPicPr>
              <p:blipFill>
                <a:blip r:embed="rId1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2080382" y="6136502"/>
                  <a:ext cx="718383" cy="5904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26" name="Picture 2" descr="C:\Users\u218433\Documents\Documents\Data\Microscope images\Leica SP5\112 149 ESSENTIALITY EXPERIMENT\For fig\48hpt 112-149+ OVERLAY.tif"/>
                <p:cNvPicPr>
                  <a:picLocks noChangeAspect="1" noChangeArrowheads="1"/>
                </p:cNvPicPr>
                <p:nvPr/>
              </p:nvPicPr>
              <p:blipFill>
                <a:blip r:embed="rId1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2079893" y="7382230"/>
                  <a:ext cx="718871" cy="5904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27" name="Picture 3" descr="C:\Users\u218433\Documents\Documents\Data\Microscope images\Leica SP5\112 149 ESSENTIALITY EXPERIMENT\For fig\48hpt 112-149+ EGFP.tif"/>
                <p:cNvPicPr>
                  <a:picLocks noChangeAspect="1" noChangeArrowheads="1"/>
                </p:cNvPicPr>
                <p:nvPr/>
              </p:nvPicPr>
              <p:blipFill>
                <a:blip r:embed="rId1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1337700" y="7382230"/>
                  <a:ext cx="718382" cy="5904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28" name="Picture 4" descr="C:\Users\u218433\Documents\Documents\Data\Microscope images\Leica SP5\112 149 ESSENTIALITY EXPERIMENT\For fig\48hpt 112-149+ 149.tif"/>
                <p:cNvPicPr>
                  <a:picLocks noChangeAspect="1" noChangeArrowheads="1"/>
                </p:cNvPicPr>
                <p:nvPr/>
              </p:nvPicPr>
              <p:blipFill>
                <a:blip r:embed="rId15" cstate="print">
                  <a:extLst>
                    <a:ext uri="{BEBA8EAE-BF5A-486C-A8C5-ECC9F3942E4B}">
                      <a14:imgProps xmlns:a14="http://schemas.microsoft.com/office/drawing/2010/main">
                        <a14:imgLayer r:embed="rId16">
                          <a14:imgEffect>
                            <a14:brightnessContrast bright="40000" contrast="-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2079891" y="6773575"/>
                  <a:ext cx="718871" cy="5904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29" name="Picture 5" descr="C:\Users\u218433\Documents\Documents\Data\Microscope images\Leica SP5\112 149 ESSENTIALITY EXPERIMENT\For fig\48hpt 112-149+ 112.tif"/>
                <p:cNvPicPr>
                  <a:picLocks noChangeAspect="1" noChangeArrowheads="1"/>
                </p:cNvPicPr>
                <p:nvPr/>
              </p:nvPicPr>
              <p:blipFill>
                <a:blip r:embed="rId17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1338752" y="6773113"/>
                  <a:ext cx="719345" cy="5904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30" name="Picture 7" descr="C:\Users\u218433\Documents\Documents\Data\Microscope images\Leica SP5\112 149 ESSENTIALITY EXPERIMENT\For fig\24hpi 112+149- 112.tif"/>
                <p:cNvPicPr>
                  <a:picLocks noChangeAspect="1" noChangeArrowheads="1"/>
                </p:cNvPicPr>
                <p:nvPr/>
              </p:nvPicPr>
              <p:blipFill>
                <a:blip r:embed="rId18" cstate="print">
                  <a:extLst>
                    <a:ext uri="{BEBA8EAE-BF5A-486C-A8C5-ECC9F3942E4B}">
                      <a14:imgProps xmlns:a14="http://schemas.microsoft.com/office/drawing/2010/main">
                        <a14:imgLayer r:embed="rId19">
                          <a14:imgEffect>
                            <a14:brightnessContrast bright="40000" contrast="-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2998601" y="5527528"/>
                  <a:ext cx="718383" cy="5904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31" name="Picture 6" descr="C:\Users\u218433\Documents\Documents\Data\Microscope images\Leica SP5\112 149 ESSENTIALITY EXPERIMENT\For fig\24hpi 112+149- overlay.tif"/>
                <p:cNvPicPr>
                  <a:picLocks noChangeAspect="1" noChangeArrowheads="1"/>
                </p:cNvPicPr>
                <p:nvPr/>
              </p:nvPicPr>
              <p:blipFill>
                <a:blip r:embed="rId20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3739038" y="6136502"/>
                  <a:ext cx="720812" cy="5904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32" name="Picture 8" descr="C:\Users\u218433\Documents\Documents\Data\Microscope images\Leica SP5\112 149 ESSENTIALITY EXPERIMENT\For fig\24hpi 112+149- 149.tif"/>
                <p:cNvPicPr>
                  <a:picLocks noChangeAspect="1" noChangeArrowheads="1"/>
                </p:cNvPicPr>
                <p:nvPr/>
              </p:nvPicPr>
              <p:blipFill>
                <a:blip r:embed="rId21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3738597" y="5527528"/>
                  <a:ext cx="718383" cy="5904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33" name="Picture 9" descr="C:\Users\u218433\Documents\Documents\Data\Microscope images\Leica SP5\112 149 ESSENTIALITY EXPERIMENT\For fig\24hpi 112+149- egfp.tif"/>
                <p:cNvPicPr>
                  <a:picLocks noChangeAspect="1" noChangeArrowheads="1"/>
                </p:cNvPicPr>
                <p:nvPr/>
              </p:nvPicPr>
              <p:blipFill>
                <a:blip r:embed="rId22" cstate="print">
                  <a:extLst>
                    <a:ext uri="{BEBA8EAE-BF5A-486C-A8C5-ECC9F3942E4B}">
                      <a14:imgProps xmlns:a14="http://schemas.microsoft.com/office/drawing/2010/main">
                        <a14:imgLayer r:embed="rId23">
                          <a14:imgEffect>
                            <a14:brightnessContrast bright="40000" contrast="-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2997438" y="6135928"/>
                  <a:ext cx="720812" cy="5904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34" name="Picture 14" descr="C:\Users\u218433\Documents\Documents\Data\Microscope images\Leica SP5\112 149 ESSENTIALITY EXPERIMENT\For fig\24hpi 112+149+ overlay.tif"/>
                <p:cNvPicPr>
                  <a:picLocks noChangeAspect="1" noChangeArrowheads="1"/>
                </p:cNvPicPr>
                <p:nvPr/>
              </p:nvPicPr>
              <p:blipFill>
                <a:blip r:embed="rId2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3739893" y="4892400"/>
                  <a:ext cx="718383" cy="5904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35" name="Picture 15" descr="C:\Users\u218433\Documents\Documents\Data\Microscope images\Leica SP5\112 149 ESSENTIALITY EXPERIMENT\For fig\24hpi 112+149+ egfp.tif"/>
                <p:cNvPicPr>
                  <a:picLocks noChangeAspect="1" noChangeArrowheads="1"/>
                </p:cNvPicPr>
                <p:nvPr/>
              </p:nvPicPr>
              <p:blipFill>
                <a:blip r:embed="rId25" cstate="print">
                  <a:extLst>
                    <a:ext uri="{BEBA8EAE-BF5A-486C-A8C5-ECC9F3942E4B}">
                      <a14:imgProps xmlns:a14="http://schemas.microsoft.com/office/drawing/2010/main">
                        <a14:imgLayer r:embed="rId26">
                          <a14:imgEffect>
                            <a14:brightnessContrast bright="40000" contrast="-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2997212" y="4892400"/>
                  <a:ext cx="718383" cy="5904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36" name="Picture 16" descr="C:\Users\u218433\Documents\Documents\Data\Microscope images\Leica SP5\112 149 ESSENTIALITY EXPERIMENT\For fig\24hpi 112+149+ 149.tif"/>
                <p:cNvPicPr>
                  <a:picLocks noChangeAspect="1" noChangeArrowheads="1"/>
                </p:cNvPicPr>
                <p:nvPr/>
              </p:nvPicPr>
              <p:blipFill>
                <a:blip r:embed="rId27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3739286" y="4284000"/>
                  <a:ext cx="720564" cy="5904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37" name="Picture 17" descr="C:\Users\u218433\Documents\Documents\Data\Microscope images\Leica SP5\112 149 ESSENTIALITY EXPERIMENT\For fig\24hpi 112+149+ 112.tif"/>
                <p:cNvPicPr>
                  <a:picLocks noChangeAspect="1" noChangeArrowheads="1"/>
                </p:cNvPicPr>
                <p:nvPr/>
              </p:nvPicPr>
              <p:blipFill>
                <a:blip r:embed="rId28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2997438" y="4284000"/>
                  <a:ext cx="718383" cy="5904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38" name="Picture 7" descr="C:\Users\u218433\Documents\Documents\Data\Microscope images\Leica SP5\112 149 ESSENTIALITY EXPERIMENT\48 hours post-infection\112+ 149- plaques\ESSENTIALITY 112-149 EXPERIMENT 48h PT.lif - CO 48h - 8 OVERLAY.tif"/>
                <p:cNvPicPr>
                  <a:picLocks noChangeAspect="1" noChangeArrowheads="1"/>
                </p:cNvPicPr>
                <p:nvPr/>
              </p:nvPicPr>
              <p:blipFill>
                <a:blip r:embed="rId29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5402404" y="6135928"/>
                  <a:ext cx="719186" cy="5904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39" name="Picture 9" descr="C:\Users\u218433\Documents\Documents\Data\Microscope images\Leica SP5\112 149 ESSENTIALITY EXPERIMENT\48 hours post-infection\112+ 149- plaques\C3-ESSENTIALITY 112-149 EXPERIMENT 48h PT.lif - CO 48h - 8 ORF149.tif"/>
                <p:cNvPicPr>
                  <a:picLocks noChangeAspect="1" noChangeArrowheads="1"/>
                </p:cNvPicPr>
                <p:nvPr/>
              </p:nvPicPr>
              <p:blipFill>
                <a:blip r:embed="rId30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5401698" y="5527528"/>
                  <a:ext cx="719187" cy="5904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40" name="Picture 10" descr="C:\Users\u218433\Documents\Documents\Data\Microscope images\Leica SP5\112 149 ESSENTIALITY EXPERIMENT\48 hours post-infection\112+ 149- plaques\C4-ESSENTIALITY 112-149 EXPERIMENT 48h PT.lif - CO 48h - 8 ORF112.tif"/>
                <p:cNvPicPr>
                  <a:picLocks noChangeAspect="1" noChangeArrowheads="1"/>
                </p:cNvPicPr>
                <p:nvPr/>
              </p:nvPicPr>
              <p:blipFill>
                <a:blip r:embed="rId31" cstate="print">
                  <a:extLst>
                    <a:ext uri="{BEBA8EAE-BF5A-486C-A8C5-ECC9F3942E4B}">
                      <a14:imgProps xmlns:a14="http://schemas.microsoft.com/office/drawing/2010/main">
                        <a14:imgLayer r:embed="rId32">
                          <a14:imgEffect>
                            <a14:brightnessContrast bright="40000" contrast="-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4661577" y="5527528"/>
                  <a:ext cx="719186" cy="5904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41" name="Picture 11" descr="C:\Users\u218433\Documents\Documents\Data\Microscope images\Leica SP5\112 149 ESSENTIALITY EXPERIMENT\48 hours post-infection\112+ 149- plaques\C2-ESSENTIALITY 112-149 EXPERIMENT 48h PT.lif - CO 48h - 8 VIRUS.tif"/>
                <p:cNvPicPr>
                  <a:picLocks noChangeAspect="1" noChangeArrowheads="1"/>
                </p:cNvPicPr>
                <p:nvPr/>
              </p:nvPicPr>
              <p:blipFill>
                <a:blip r:embed="rId33" cstate="print">
                  <a:extLst>
                    <a:ext uri="{BEBA8EAE-BF5A-486C-A8C5-ECC9F3942E4B}">
                      <a14:imgProps xmlns:a14="http://schemas.microsoft.com/office/drawing/2010/main">
                        <a14:imgLayer r:embed="rId34">
                          <a14:imgEffect>
                            <a14:brightnessContrast bright="40000" contrast="-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4660525" y="6135928"/>
                  <a:ext cx="720238" cy="5904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42" name="Picture 18" descr="C:\Users\u218433\Documents\Documents\Data\Microscope images\Leica SP5\112 149 ESSENTIALITY EXPERIMENT\48 hours post-infection\112+149+ plaques\C2-ESSENTIALITY 112-149 EXPERIMENT 48h PT.lif - CO 48h - 112.jpg"/>
                <p:cNvPicPr>
                  <a:picLocks noChangeAspect="1" noChangeArrowheads="1"/>
                </p:cNvPicPr>
                <p:nvPr/>
              </p:nvPicPr>
              <p:blipFill>
                <a:blip r:embed="rId3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4661577" y="4284000"/>
                  <a:ext cx="718383" cy="5904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43" name="Picture 19" descr="C:\Users\u218433\Documents\Documents\Data\Microscope images\Leica SP5\112 149 ESSENTIALITY EXPERIMENT\48 hours post-infection\112+149+ plaques\ESSENTIALITY 112-149 EXPERIMENT 48h PT.lif - CO 48h - 6 OVERLAY.jpg"/>
                <p:cNvPicPr>
                  <a:picLocks noChangeAspect="1" noChangeArrowheads="1"/>
                </p:cNvPicPr>
                <p:nvPr/>
              </p:nvPicPr>
              <p:blipFill>
                <a:blip r:embed="rId36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5402404" y="4892400"/>
                  <a:ext cx="719186" cy="5904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44" name="Picture 20" descr="C:\Users\u218433\Documents\Documents\Data\Microscope images\Leica SP5\112 149 ESSENTIALITY EXPERIMENT\48 hours post-infection\112+149+ plaques\C2-ESSENTIALITY 112-149 EXPERIMENT 48h PT.lif - CO 48h - 6 VIRUS.tif"/>
                <p:cNvPicPr>
                  <a:picLocks noChangeAspect="1" noChangeArrowheads="1"/>
                </p:cNvPicPr>
                <p:nvPr/>
              </p:nvPicPr>
              <p:blipFill>
                <a:blip r:embed="rId37" cstate="print">
                  <a:extLst>
                    <a:ext uri="{BEBA8EAE-BF5A-486C-A8C5-ECC9F3942E4B}">
                      <a14:imgProps xmlns:a14="http://schemas.microsoft.com/office/drawing/2010/main">
                        <a14:imgLayer r:embed="rId38">
                          <a14:imgEffect>
                            <a14:brightnessContrast bright="40000" contrast="-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4660524" y="4892400"/>
                  <a:ext cx="720239" cy="5904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45" name="Picture 21" descr="C:\Users\u218433\Documents\Documents\Data\Microscope images\Leica SP5\112 149 ESSENTIALITY EXPERIMENT\48 hours post-infection\112+149+ plaques\C3-ESSENTIALITY 112-149 EXPERIMENT 48h PT.lif - CO 48h - 6 ORF149.tif"/>
                <p:cNvPicPr>
                  <a:picLocks noChangeAspect="1" noChangeArrowheads="1"/>
                </p:cNvPicPr>
                <p:nvPr/>
              </p:nvPicPr>
              <p:blipFill>
                <a:blip r:embed="rId39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5401698" y="4284000"/>
                  <a:ext cx="719189" cy="5904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46" name="Picture 9" descr="C:\Users\u218433\Documents\Documents\Data\Microscope images\Leica SP5\112 149 ESSENTIALITY EXPERIMENT\48 hours post-infection\112+ 149- plaques\C3-ESSENTIALITY 112-149 EXPERIMENT 48h PT.lif - CO 48h - 8 ORF149.tif"/>
                <p:cNvPicPr>
                  <a:picLocks noChangeAspect="1" noChangeArrowheads="1"/>
                </p:cNvPicPr>
                <p:nvPr/>
              </p:nvPicPr>
              <p:blipFill>
                <a:blip r:embed="rId30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2998601" y="6773340"/>
                  <a:ext cx="719187" cy="5904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47" name="Picture 2" descr="C:\Users\u218433\Documents\Documents\Data\Microscope images\Leica SP5\112 149 ESSENTIALITY EXPERIMENT\For fig\24h 112-149+ overlay.tif"/>
                <p:cNvPicPr>
                  <a:picLocks noChangeAspect="1" noChangeArrowheads="1"/>
                </p:cNvPicPr>
                <p:nvPr/>
              </p:nvPicPr>
              <p:blipFill>
                <a:blip r:embed="rId40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3740201" y="7381740"/>
                  <a:ext cx="719680" cy="5904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48" name="Picture 3" descr="C:\Users\u218433\Documents\Documents\Data\Microscope images\Leica SP5\112 149 ESSENTIALITY EXPERIMENT\For fig\24h 112-149+ egfp.tif"/>
                <p:cNvPicPr>
                  <a:picLocks noChangeAspect="1" noChangeArrowheads="1"/>
                </p:cNvPicPr>
                <p:nvPr/>
              </p:nvPicPr>
              <p:blipFill>
                <a:blip r:embed="rId41" cstate="print">
                  <a:extLst>
                    <a:ext uri="{BEBA8EAE-BF5A-486C-A8C5-ECC9F3942E4B}">
                      <a14:imgProps xmlns:a14="http://schemas.microsoft.com/office/drawing/2010/main">
                        <a14:imgLayer r:embed="rId42">
                          <a14:imgEffect>
                            <a14:brightnessContrast bright="20000" contrast="-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2998601" y="7381740"/>
                  <a:ext cx="719187" cy="5904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49" name="Picture 4" descr="C:\Users\u218433\Documents\Documents\Data\Microscope images\Leica SP5\112 149 ESSENTIALITY EXPERIMENT\For fig\24h 112-149+ 149.tif"/>
                <p:cNvPicPr>
                  <a:picLocks noChangeAspect="1" noChangeArrowheads="1"/>
                </p:cNvPicPr>
                <p:nvPr/>
              </p:nvPicPr>
              <p:blipFill>
                <a:blip r:embed="rId4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3740201" y="6773113"/>
                  <a:ext cx="721496" cy="5904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cxnSp>
              <p:nvCxnSpPr>
                <p:cNvPr id="50" name="Connecteur droit 49"/>
                <p:cNvCxnSpPr/>
                <p:nvPr/>
              </p:nvCxnSpPr>
              <p:spPr>
                <a:xfrm>
                  <a:off x="2648100" y="5436096"/>
                  <a:ext cx="122400" cy="0"/>
                </a:xfrm>
                <a:prstGeom prst="line">
                  <a:avLst/>
                </a:prstGeom>
                <a:ln w="1905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1" name="Connecteur droit 50"/>
                <p:cNvCxnSpPr/>
                <p:nvPr/>
              </p:nvCxnSpPr>
              <p:spPr>
                <a:xfrm>
                  <a:off x="2648100" y="6683128"/>
                  <a:ext cx="122400" cy="0"/>
                </a:xfrm>
                <a:prstGeom prst="line">
                  <a:avLst/>
                </a:prstGeom>
                <a:ln w="1905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2" name="Connecteur droit 51"/>
                <p:cNvCxnSpPr/>
                <p:nvPr/>
              </p:nvCxnSpPr>
              <p:spPr>
                <a:xfrm>
                  <a:off x="2647818" y="7921740"/>
                  <a:ext cx="122400" cy="0"/>
                </a:xfrm>
                <a:prstGeom prst="line">
                  <a:avLst/>
                </a:prstGeom>
                <a:ln w="1905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3" name="Connecteur droit 52"/>
                <p:cNvCxnSpPr/>
                <p:nvPr/>
              </p:nvCxnSpPr>
              <p:spPr>
                <a:xfrm>
                  <a:off x="4309766" y="5436000"/>
                  <a:ext cx="122400" cy="0"/>
                </a:xfrm>
                <a:prstGeom prst="line">
                  <a:avLst/>
                </a:prstGeom>
                <a:ln w="1905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4" name="Connecteur droit 53"/>
                <p:cNvCxnSpPr/>
                <p:nvPr/>
              </p:nvCxnSpPr>
              <p:spPr>
                <a:xfrm>
                  <a:off x="4309766" y="6683128"/>
                  <a:ext cx="122400" cy="0"/>
                </a:xfrm>
                <a:prstGeom prst="line">
                  <a:avLst/>
                </a:prstGeom>
                <a:ln w="1905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5" name="Connecteur droit 54"/>
                <p:cNvCxnSpPr/>
                <p:nvPr/>
              </p:nvCxnSpPr>
              <p:spPr>
                <a:xfrm>
                  <a:off x="4309484" y="7921740"/>
                  <a:ext cx="122400" cy="0"/>
                </a:xfrm>
                <a:prstGeom prst="line">
                  <a:avLst/>
                </a:prstGeom>
                <a:ln w="1905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6" name="ZoneTexte 55"/>
                <p:cNvSpPr txBox="1"/>
                <p:nvPr/>
              </p:nvSpPr>
              <p:spPr>
                <a:xfrm>
                  <a:off x="2477434" y="5302800"/>
                  <a:ext cx="396000" cy="1692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BE" sz="5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 20µm</a:t>
                  </a:r>
                  <a:endParaRPr lang="en-GB" sz="5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7" name="ZoneTexte 56"/>
                <p:cNvSpPr txBox="1"/>
                <p:nvPr/>
              </p:nvSpPr>
              <p:spPr>
                <a:xfrm>
                  <a:off x="2478900" y="6549928"/>
                  <a:ext cx="396000" cy="1692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BE" sz="5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 20µm</a:t>
                  </a:r>
                  <a:endParaRPr lang="en-GB" sz="5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8" name="ZoneTexte 57"/>
                <p:cNvSpPr txBox="1"/>
                <p:nvPr/>
              </p:nvSpPr>
              <p:spPr>
                <a:xfrm>
                  <a:off x="2478900" y="7788863"/>
                  <a:ext cx="396000" cy="1692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BE" sz="5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 20µm</a:t>
                  </a:r>
                  <a:endParaRPr lang="en-GB" sz="5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9" name="ZoneTexte 58"/>
                <p:cNvSpPr txBox="1"/>
                <p:nvPr/>
              </p:nvSpPr>
              <p:spPr>
                <a:xfrm>
                  <a:off x="4138638" y="5302800"/>
                  <a:ext cx="396000" cy="1692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BE" sz="5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 20µm</a:t>
                  </a:r>
                  <a:endParaRPr lang="en-GB" sz="5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0" name="ZoneTexte 59"/>
                <p:cNvSpPr txBox="1"/>
                <p:nvPr/>
              </p:nvSpPr>
              <p:spPr>
                <a:xfrm>
                  <a:off x="4138638" y="6549928"/>
                  <a:ext cx="396000" cy="1692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BE" sz="5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 20µm</a:t>
                  </a:r>
                  <a:endParaRPr lang="en-GB" sz="5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1" name="ZoneTexte 60"/>
                <p:cNvSpPr txBox="1"/>
                <p:nvPr/>
              </p:nvSpPr>
              <p:spPr>
                <a:xfrm>
                  <a:off x="4138638" y="7788862"/>
                  <a:ext cx="396000" cy="1692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BE" sz="5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 20µm</a:t>
                  </a:r>
                  <a:endParaRPr lang="en-GB" sz="5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62" name="Connecteur droit 61"/>
                <p:cNvCxnSpPr/>
                <p:nvPr/>
              </p:nvCxnSpPr>
              <p:spPr>
                <a:xfrm>
                  <a:off x="5997012" y="5436000"/>
                  <a:ext cx="93600" cy="0"/>
                </a:xfrm>
                <a:prstGeom prst="line">
                  <a:avLst/>
                </a:prstGeom>
                <a:ln w="1905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3" name="ZoneTexte 62"/>
                <p:cNvSpPr txBox="1"/>
                <p:nvPr/>
              </p:nvSpPr>
              <p:spPr>
                <a:xfrm>
                  <a:off x="5804076" y="5301921"/>
                  <a:ext cx="396000" cy="1692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BE" sz="5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 50µm</a:t>
                  </a:r>
                  <a:endParaRPr lang="en-GB" sz="5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64" name="Connecteur droit 63"/>
                <p:cNvCxnSpPr/>
                <p:nvPr/>
              </p:nvCxnSpPr>
              <p:spPr>
                <a:xfrm>
                  <a:off x="5997456" y="6683128"/>
                  <a:ext cx="93600" cy="0"/>
                </a:xfrm>
                <a:prstGeom prst="line">
                  <a:avLst/>
                </a:prstGeom>
                <a:ln w="1905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5" name="ZoneTexte 64"/>
                <p:cNvSpPr txBox="1"/>
                <p:nvPr/>
              </p:nvSpPr>
              <p:spPr>
                <a:xfrm>
                  <a:off x="5804076" y="6549927"/>
                  <a:ext cx="396000" cy="1692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BE" sz="5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 50µm</a:t>
                  </a:r>
                  <a:endParaRPr lang="en-GB" sz="5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6" name="ZoneTexte 65"/>
                <p:cNvSpPr txBox="1"/>
                <p:nvPr/>
              </p:nvSpPr>
              <p:spPr>
                <a:xfrm>
                  <a:off x="2988145" y="8019078"/>
                  <a:ext cx="1470576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fr-BE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ot </a:t>
                  </a:r>
                  <a:r>
                    <a:rPr lang="fr-BE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detected</a:t>
                  </a:r>
                  <a:endParaRPr lang="en-GB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7" name="ZoneTexte 66"/>
                <p:cNvSpPr txBox="1"/>
                <p:nvPr/>
              </p:nvSpPr>
              <p:spPr>
                <a:xfrm>
                  <a:off x="4651001" y="8019078"/>
                  <a:ext cx="1470576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fr-BE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ot </a:t>
                  </a:r>
                  <a:r>
                    <a:rPr lang="fr-BE" sz="12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detected</a:t>
                  </a:r>
                  <a:endParaRPr lang="en-GB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8" name="ZoneTexte 67"/>
                <p:cNvSpPr txBox="1"/>
                <p:nvPr/>
              </p:nvSpPr>
              <p:spPr>
                <a:xfrm>
                  <a:off x="1490399" y="4251712"/>
                  <a:ext cx="641000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l-GR" sz="7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α</a:t>
                  </a:r>
                  <a:r>
                    <a:rPr lang="fr-BE" sz="7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-ORF112</a:t>
                  </a:r>
                  <a:endParaRPr lang="en-GB" sz="7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9" name="ZoneTexte 68"/>
                <p:cNvSpPr txBox="1"/>
                <p:nvPr/>
              </p:nvSpPr>
              <p:spPr>
                <a:xfrm>
                  <a:off x="1645299" y="4856939"/>
                  <a:ext cx="481592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BE" sz="7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EGFP</a:t>
                  </a:r>
                  <a:endParaRPr lang="en-GB" sz="7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0" name="ZoneTexte 69"/>
                <p:cNvSpPr txBox="1"/>
                <p:nvPr/>
              </p:nvSpPr>
              <p:spPr>
                <a:xfrm>
                  <a:off x="3146174" y="4251712"/>
                  <a:ext cx="64100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l-GR" sz="7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α</a:t>
                  </a:r>
                  <a:r>
                    <a:rPr lang="fr-BE" sz="7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-ORF112</a:t>
                  </a:r>
                  <a:endParaRPr lang="en-GB" sz="7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r"/>
                  <a:endParaRPr lang="en-GB" sz="7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1" name="ZoneTexte 70"/>
                <p:cNvSpPr txBox="1"/>
                <p:nvPr/>
              </p:nvSpPr>
              <p:spPr>
                <a:xfrm>
                  <a:off x="3301074" y="4856939"/>
                  <a:ext cx="481592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BE" sz="7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EGFP</a:t>
                  </a:r>
                  <a:endParaRPr lang="en-GB" sz="7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2" name="ZoneTexte 71"/>
                <p:cNvSpPr txBox="1"/>
                <p:nvPr/>
              </p:nvSpPr>
              <p:spPr>
                <a:xfrm>
                  <a:off x="4809921" y="4251712"/>
                  <a:ext cx="641000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l-GR" sz="7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α</a:t>
                  </a:r>
                  <a:r>
                    <a:rPr lang="fr-BE" sz="7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-ORF112</a:t>
                  </a:r>
                  <a:endParaRPr lang="en-GB" sz="7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3" name="ZoneTexte 72"/>
                <p:cNvSpPr txBox="1"/>
                <p:nvPr/>
              </p:nvSpPr>
              <p:spPr>
                <a:xfrm>
                  <a:off x="4969901" y="4856939"/>
                  <a:ext cx="481592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BE" sz="7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EGFP</a:t>
                  </a:r>
                  <a:endParaRPr lang="en-GB" sz="7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74" name="Groupe 73"/>
                <p:cNvGrpSpPr/>
                <p:nvPr/>
              </p:nvGrpSpPr>
              <p:grpSpPr>
                <a:xfrm>
                  <a:off x="1310697" y="4251712"/>
                  <a:ext cx="1568757" cy="805282"/>
                  <a:chOff x="1272597" y="4242302"/>
                  <a:chExt cx="1568757" cy="805282"/>
                </a:xfrm>
              </p:grpSpPr>
              <p:sp>
                <p:nvSpPr>
                  <p:cNvPr id="136" name="ZoneTexte 135"/>
                  <p:cNvSpPr txBox="1"/>
                  <p:nvPr/>
                </p:nvSpPr>
                <p:spPr>
                  <a:xfrm>
                    <a:off x="2117963" y="4242302"/>
                    <a:ext cx="717193" cy="20005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l-GR" sz="700" b="1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α</a:t>
                    </a:r>
                    <a:r>
                      <a:rPr lang="fr-BE" sz="700" b="1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-ORF149</a:t>
                    </a:r>
                    <a:endParaRPr lang="en-GB" sz="7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37" name="ZoneTexte 136"/>
                  <p:cNvSpPr txBox="1"/>
                  <p:nvPr/>
                </p:nvSpPr>
                <p:spPr>
                  <a:xfrm>
                    <a:off x="2070854" y="4847529"/>
                    <a:ext cx="770500" cy="20005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GB" sz="700" b="1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Overlay/</a:t>
                    </a:r>
                    <a:r>
                      <a:rPr lang="en-GB" sz="700" b="1" dirty="0" err="1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Dapi</a:t>
                    </a:r>
                    <a:endParaRPr lang="en-GB" sz="7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38" name="ZoneTexte 137"/>
                  <p:cNvSpPr txBox="1"/>
                  <p:nvPr/>
                </p:nvSpPr>
                <p:spPr>
                  <a:xfrm>
                    <a:off x="1272597" y="4242302"/>
                    <a:ext cx="146744" cy="20005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700" b="1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</a:t>
                    </a:r>
                  </a:p>
                </p:txBody>
              </p:sp>
              <p:sp>
                <p:nvSpPr>
                  <p:cNvPr id="139" name="ZoneTexte 138"/>
                  <p:cNvSpPr txBox="1"/>
                  <p:nvPr/>
                </p:nvSpPr>
                <p:spPr>
                  <a:xfrm>
                    <a:off x="2011158" y="4242302"/>
                    <a:ext cx="146744" cy="20005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700" b="1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b</a:t>
                    </a:r>
                  </a:p>
                </p:txBody>
              </p:sp>
              <p:sp>
                <p:nvSpPr>
                  <p:cNvPr id="140" name="ZoneTexte 139"/>
                  <p:cNvSpPr txBox="1"/>
                  <p:nvPr/>
                </p:nvSpPr>
                <p:spPr>
                  <a:xfrm>
                    <a:off x="1272597" y="4847529"/>
                    <a:ext cx="146744" cy="20005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700" b="1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</a:t>
                    </a:r>
                  </a:p>
                </p:txBody>
              </p:sp>
              <p:sp>
                <p:nvSpPr>
                  <p:cNvPr id="141" name="ZoneTexte 140"/>
                  <p:cNvSpPr txBox="1"/>
                  <p:nvPr/>
                </p:nvSpPr>
                <p:spPr>
                  <a:xfrm>
                    <a:off x="2011158" y="4847529"/>
                    <a:ext cx="146744" cy="20005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700" b="1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d</a:t>
                    </a:r>
                  </a:p>
                </p:txBody>
              </p:sp>
            </p:grpSp>
            <p:grpSp>
              <p:nvGrpSpPr>
                <p:cNvPr id="75" name="Groupe 74"/>
                <p:cNvGrpSpPr/>
                <p:nvPr/>
              </p:nvGrpSpPr>
              <p:grpSpPr>
                <a:xfrm>
                  <a:off x="3768539" y="4251712"/>
                  <a:ext cx="770500" cy="805282"/>
                  <a:chOff x="2074664" y="4241464"/>
                  <a:chExt cx="770500" cy="805282"/>
                </a:xfrm>
              </p:grpSpPr>
              <p:sp>
                <p:nvSpPr>
                  <p:cNvPr id="130" name="ZoneTexte 129"/>
                  <p:cNvSpPr txBox="1"/>
                  <p:nvPr/>
                </p:nvSpPr>
                <p:spPr>
                  <a:xfrm>
                    <a:off x="2117963" y="4241464"/>
                    <a:ext cx="717193" cy="20005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l-GR" sz="700" b="1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α</a:t>
                    </a:r>
                    <a:r>
                      <a:rPr lang="fr-BE" sz="700" b="1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-ORF149</a:t>
                    </a:r>
                    <a:endParaRPr lang="en-GB" sz="7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31" name="ZoneTexte 130"/>
                  <p:cNvSpPr txBox="1"/>
                  <p:nvPr/>
                </p:nvSpPr>
                <p:spPr>
                  <a:xfrm>
                    <a:off x="2074664" y="4846691"/>
                    <a:ext cx="770500" cy="20005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GB" sz="700" b="1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Overlay/</a:t>
                    </a:r>
                    <a:r>
                      <a:rPr lang="en-GB" sz="700" b="1" dirty="0" err="1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Dapi</a:t>
                    </a:r>
                    <a:endParaRPr lang="en-GB" sz="7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76" name="Groupe 75"/>
                <p:cNvGrpSpPr/>
                <p:nvPr/>
              </p:nvGrpSpPr>
              <p:grpSpPr>
                <a:xfrm>
                  <a:off x="5432286" y="4251712"/>
                  <a:ext cx="770500" cy="805282"/>
                  <a:chOff x="2074664" y="4246059"/>
                  <a:chExt cx="770500" cy="805282"/>
                </a:xfrm>
              </p:grpSpPr>
              <p:sp>
                <p:nvSpPr>
                  <p:cNvPr id="124" name="ZoneTexte 123"/>
                  <p:cNvSpPr txBox="1"/>
                  <p:nvPr/>
                </p:nvSpPr>
                <p:spPr>
                  <a:xfrm>
                    <a:off x="2117963" y="4246059"/>
                    <a:ext cx="717193" cy="20005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l-GR" sz="700" b="1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α</a:t>
                    </a:r>
                    <a:r>
                      <a:rPr lang="fr-BE" sz="700" b="1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-ORF149</a:t>
                    </a:r>
                    <a:endParaRPr lang="en-GB" sz="7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25" name="ZoneTexte 124"/>
                  <p:cNvSpPr txBox="1"/>
                  <p:nvPr/>
                </p:nvSpPr>
                <p:spPr>
                  <a:xfrm>
                    <a:off x="2074664" y="4851286"/>
                    <a:ext cx="770500" cy="20005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GB" sz="700" b="1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Overlay/</a:t>
                    </a:r>
                    <a:r>
                      <a:rPr lang="en-GB" sz="700" b="1" dirty="0" err="1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Dapi</a:t>
                    </a:r>
                    <a:endParaRPr lang="en-GB" sz="7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77" name="ZoneTexte 76"/>
                <p:cNvSpPr txBox="1"/>
                <p:nvPr/>
              </p:nvSpPr>
              <p:spPr>
                <a:xfrm>
                  <a:off x="1492163" y="5491136"/>
                  <a:ext cx="641000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l-GR" sz="7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α</a:t>
                  </a:r>
                  <a:r>
                    <a:rPr lang="fr-BE" sz="7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-ORF112</a:t>
                  </a:r>
                  <a:endParaRPr lang="en-GB" sz="7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8" name="ZoneTexte 77"/>
                <p:cNvSpPr txBox="1"/>
                <p:nvPr/>
              </p:nvSpPr>
              <p:spPr>
                <a:xfrm>
                  <a:off x="1647063" y="6096363"/>
                  <a:ext cx="481592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BE" sz="7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EGFP</a:t>
                  </a:r>
                  <a:endParaRPr lang="en-GB" sz="7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9" name="ZoneTexte 78"/>
                <p:cNvSpPr txBox="1"/>
                <p:nvPr/>
              </p:nvSpPr>
              <p:spPr>
                <a:xfrm>
                  <a:off x="3147938" y="5491136"/>
                  <a:ext cx="641000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l-GR" sz="7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α</a:t>
                  </a:r>
                  <a:r>
                    <a:rPr lang="fr-BE" sz="7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-ORF112</a:t>
                  </a:r>
                  <a:endParaRPr lang="en-GB" sz="7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0" name="ZoneTexte 79"/>
                <p:cNvSpPr txBox="1"/>
                <p:nvPr/>
              </p:nvSpPr>
              <p:spPr>
                <a:xfrm>
                  <a:off x="3307918" y="6096363"/>
                  <a:ext cx="481592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BE" sz="7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EGFP</a:t>
                  </a:r>
                  <a:endParaRPr lang="en-GB" sz="7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1" name="ZoneTexte 80"/>
                <p:cNvSpPr txBox="1"/>
                <p:nvPr/>
              </p:nvSpPr>
              <p:spPr>
                <a:xfrm>
                  <a:off x="4811685" y="5491136"/>
                  <a:ext cx="641000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l-GR" sz="7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α</a:t>
                  </a:r>
                  <a:r>
                    <a:rPr lang="fr-BE" sz="7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-ORF112</a:t>
                  </a:r>
                  <a:endParaRPr lang="en-GB" sz="7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2" name="ZoneTexte 81"/>
                <p:cNvSpPr txBox="1"/>
                <p:nvPr/>
              </p:nvSpPr>
              <p:spPr>
                <a:xfrm>
                  <a:off x="4971665" y="6096363"/>
                  <a:ext cx="481592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BE" sz="7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EGFP</a:t>
                  </a:r>
                  <a:endParaRPr lang="en-GB" sz="7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83" name="Groupe 82"/>
                <p:cNvGrpSpPr/>
                <p:nvPr/>
              </p:nvGrpSpPr>
              <p:grpSpPr>
                <a:xfrm>
                  <a:off x="1310201" y="5491136"/>
                  <a:ext cx="1571017" cy="805282"/>
                  <a:chOff x="1270337" y="4242302"/>
                  <a:chExt cx="1571017" cy="805282"/>
                </a:xfrm>
              </p:grpSpPr>
              <p:sp>
                <p:nvSpPr>
                  <p:cNvPr id="118" name="ZoneTexte 117"/>
                  <p:cNvSpPr txBox="1"/>
                  <p:nvPr/>
                </p:nvSpPr>
                <p:spPr>
                  <a:xfrm>
                    <a:off x="2117963" y="4242302"/>
                    <a:ext cx="717193" cy="20005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l-GR" sz="700" b="1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α</a:t>
                    </a:r>
                    <a:r>
                      <a:rPr lang="fr-BE" sz="700" b="1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-ORF149</a:t>
                    </a:r>
                    <a:endParaRPr lang="en-GB" sz="7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19" name="ZoneTexte 118"/>
                  <p:cNvSpPr txBox="1"/>
                  <p:nvPr/>
                </p:nvSpPr>
                <p:spPr>
                  <a:xfrm>
                    <a:off x="2070854" y="4847529"/>
                    <a:ext cx="770500" cy="20005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GB" sz="700" b="1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Overlay/</a:t>
                    </a:r>
                    <a:r>
                      <a:rPr lang="en-GB" sz="700" b="1" dirty="0" err="1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Dapi</a:t>
                    </a:r>
                    <a:endParaRPr lang="en-GB" sz="7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20" name="ZoneTexte 119"/>
                  <p:cNvSpPr txBox="1"/>
                  <p:nvPr/>
                </p:nvSpPr>
                <p:spPr>
                  <a:xfrm>
                    <a:off x="1270337" y="4242302"/>
                    <a:ext cx="146744" cy="20005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700" b="1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e</a:t>
                    </a:r>
                  </a:p>
                </p:txBody>
              </p:sp>
              <p:sp>
                <p:nvSpPr>
                  <p:cNvPr id="121" name="ZoneTexte 120"/>
                  <p:cNvSpPr txBox="1"/>
                  <p:nvPr/>
                </p:nvSpPr>
                <p:spPr>
                  <a:xfrm>
                    <a:off x="2008337" y="4242302"/>
                    <a:ext cx="146744" cy="20005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700" b="1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</a:t>
                    </a:r>
                  </a:p>
                </p:txBody>
              </p:sp>
              <p:sp>
                <p:nvSpPr>
                  <p:cNvPr id="122" name="ZoneTexte 121"/>
                  <p:cNvSpPr txBox="1"/>
                  <p:nvPr/>
                </p:nvSpPr>
                <p:spPr>
                  <a:xfrm>
                    <a:off x="1270337" y="4847529"/>
                    <a:ext cx="146744" cy="20005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700" b="1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g</a:t>
                    </a:r>
                  </a:p>
                </p:txBody>
              </p:sp>
              <p:sp>
                <p:nvSpPr>
                  <p:cNvPr id="123" name="ZoneTexte 122"/>
                  <p:cNvSpPr txBox="1"/>
                  <p:nvPr/>
                </p:nvSpPr>
                <p:spPr>
                  <a:xfrm>
                    <a:off x="2008337" y="4847529"/>
                    <a:ext cx="146744" cy="20005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700" b="1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h</a:t>
                    </a:r>
                  </a:p>
                </p:txBody>
              </p:sp>
            </p:grpSp>
            <p:grpSp>
              <p:nvGrpSpPr>
                <p:cNvPr id="84" name="Groupe 83"/>
                <p:cNvGrpSpPr/>
                <p:nvPr/>
              </p:nvGrpSpPr>
              <p:grpSpPr>
                <a:xfrm>
                  <a:off x="3770303" y="5491136"/>
                  <a:ext cx="770500" cy="805282"/>
                  <a:chOff x="2074664" y="4241464"/>
                  <a:chExt cx="770500" cy="805282"/>
                </a:xfrm>
              </p:grpSpPr>
              <p:sp>
                <p:nvSpPr>
                  <p:cNvPr id="112" name="ZoneTexte 111"/>
                  <p:cNvSpPr txBox="1"/>
                  <p:nvPr/>
                </p:nvSpPr>
                <p:spPr>
                  <a:xfrm>
                    <a:off x="2117963" y="4241464"/>
                    <a:ext cx="717193" cy="20005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l-GR" sz="700" b="1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α</a:t>
                    </a:r>
                    <a:r>
                      <a:rPr lang="fr-BE" sz="700" b="1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-ORF149</a:t>
                    </a:r>
                    <a:endParaRPr lang="en-GB" sz="7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13" name="ZoneTexte 112"/>
                  <p:cNvSpPr txBox="1"/>
                  <p:nvPr/>
                </p:nvSpPr>
                <p:spPr>
                  <a:xfrm>
                    <a:off x="2074664" y="4846691"/>
                    <a:ext cx="770500" cy="20005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GB" sz="700" b="1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Overlay/</a:t>
                    </a:r>
                    <a:r>
                      <a:rPr lang="en-GB" sz="700" b="1" dirty="0" err="1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Dapi</a:t>
                    </a:r>
                    <a:endParaRPr lang="en-GB" sz="7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85" name="Groupe 84"/>
                <p:cNvGrpSpPr/>
                <p:nvPr/>
              </p:nvGrpSpPr>
              <p:grpSpPr>
                <a:xfrm>
                  <a:off x="5434050" y="5491136"/>
                  <a:ext cx="770500" cy="805282"/>
                  <a:chOff x="2074664" y="4246059"/>
                  <a:chExt cx="770500" cy="805282"/>
                </a:xfrm>
              </p:grpSpPr>
              <p:sp>
                <p:nvSpPr>
                  <p:cNvPr id="106" name="ZoneTexte 105"/>
                  <p:cNvSpPr txBox="1"/>
                  <p:nvPr/>
                </p:nvSpPr>
                <p:spPr>
                  <a:xfrm>
                    <a:off x="2117963" y="4246059"/>
                    <a:ext cx="717193" cy="20005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l-GR" sz="700" b="1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α</a:t>
                    </a:r>
                    <a:r>
                      <a:rPr lang="fr-BE" sz="700" b="1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-ORF149</a:t>
                    </a:r>
                    <a:endParaRPr lang="en-GB" sz="7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07" name="ZoneTexte 106"/>
                  <p:cNvSpPr txBox="1"/>
                  <p:nvPr/>
                </p:nvSpPr>
                <p:spPr>
                  <a:xfrm>
                    <a:off x="2074664" y="4851286"/>
                    <a:ext cx="770500" cy="20005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GB" sz="700" b="1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Overlay/</a:t>
                    </a:r>
                    <a:r>
                      <a:rPr lang="en-GB" sz="700" b="1" dirty="0" err="1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Dapi</a:t>
                    </a:r>
                    <a:endParaRPr lang="en-GB" sz="7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86" name="ZoneTexte 85"/>
                <p:cNvSpPr txBox="1"/>
                <p:nvPr/>
              </p:nvSpPr>
              <p:spPr>
                <a:xfrm>
                  <a:off x="1494564" y="6732240"/>
                  <a:ext cx="641000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l-GR" sz="7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α</a:t>
                  </a:r>
                  <a:r>
                    <a:rPr lang="fr-BE" sz="7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-ORF112</a:t>
                  </a:r>
                  <a:endParaRPr lang="en-GB" sz="7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7" name="ZoneTexte 86"/>
                <p:cNvSpPr txBox="1"/>
                <p:nvPr/>
              </p:nvSpPr>
              <p:spPr>
                <a:xfrm>
                  <a:off x="1649464" y="7337467"/>
                  <a:ext cx="481592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BE" sz="7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EGFP</a:t>
                  </a:r>
                  <a:endParaRPr lang="en-GB" sz="7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8" name="ZoneTexte 87"/>
                <p:cNvSpPr txBox="1"/>
                <p:nvPr/>
              </p:nvSpPr>
              <p:spPr>
                <a:xfrm>
                  <a:off x="3150339" y="6732240"/>
                  <a:ext cx="641000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l-GR" sz="7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α</a:t>
                  </a:r>
                  <a:r>
                    <a:rPr lang="fr-BE" sz="7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-ORF112</a:t>
                  </a:r>
                  <a:endParaRPr lang="en-GB" sz="7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9" name="ZoneTexte 88"/>
                <p:cNvSpPr txBox="1"/>
                <p:nvPr/>
              </p:nvSpPr>
              <p:spPr>
                <a:xfrm>
                  <a:off x="3305239" y="7337467"/>
                  <a:ext cx="481592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fr-BE" sz="7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EGFP</a:t>
                  </a:r>
                  <a:endParaRPr lang="en-GB" sz="7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0" name="ZoneTexte 89"/>
                <p:cNvSpPr txBox="1"/>
                <p:nvPr/>
              </p:nvSpPr>
              <p:spPr>
                <a:xfrm>
                  <a:off x="2160228" y="6732240"/>
                  <a:ext cx="717193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l-GR" sz="7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α</a:t>
                  </a:r>
                  <a:r>
                    <a:rPr lang="fr-BE" sz="7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-ORF149</a:t>
                  </a:r>
                  <a:endParaRPr lang="en-GB" sz="7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1" name="ZoneTexte 90"/>
                <p:cNvSpPr txBox="1"/>
                <p:nvPr/>
              </p:nvSpPr>
              <p:spPr>
                <a:xfrm>
                  <a:off x="2113119" y="7337467"/>
                  <a:ext cx="770500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GB" sz="7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Overlay/</a:t>
                  </a:r>
                  <a:r>
                    <a:rPr lang="en-GB" sz="700" b="1" dirty="0" err="1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Dapi</a:t>
                  </a:r>
                  <a:endParaRPr lang="en-GB" sz="7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2" name="ZoneTexte 91"/>
                <p:cNvSpPr txBox="1"/>
                <p:nvPr/>
              </p:nvSpPr>
              <p:spPr>
                <a:xfrm>
                  <a:off x="1310201" y="6732240"/>
                  <a:ext cx="146744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fr-BE" sz="7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i</a:t>
                  </a:r>
                  <a:endParaRPr lang="en-US" sz="7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3" name="ZoneTexte 92"/>
                <p:cNvSpPr txBox="1"/>
                <p:nvPr/>
              </p:nvSpPr>
              <p:spPr>
                <a:xfrm>
                  <a:off x="2048201" y="6732240"/>
                  <a:ext cx="146744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7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j</a:t>
                  </a:r>
                </a:p>
              </p:txBody>
            </p:sp>
            <p:sp>
              <p:nvSpPr>
                <p:cNvPr id="94" name="ZoneTexte 93"/>
                <p:cNvSpPr txBox="1"/>
                <p:nvPr/>
              </p:nvSpPr>
              <p:spPr>
                <a:xfrm>
                  <a:off x="1310201" y="7337467"/>
                  <a:ext cx="146744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7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k</a:t>
                  </a:r>
                </a:p>
              </p:txBody>
            </p:sp>
            <p:sp>
              <p:nvSpPr>
                <p:cNvPr id="95" name="ZoneTexte 94"/>
                <p:cNvSpPr txBox="1"/>
                <p:nvPr/>
              </p:nvSpPr>
              <p:spPr>
                <a:xfrm>
                  <a:off x="2048201" y="7337467"/>
                  <a:ext cx="146744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7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l</a:t>
                  </a:r>
                </a:p>
              </p:txBody>
            </p:sp>
            <p:sp>
              <p:nvSpPr>
                <p:cNvPr id="96" name="ZoneTexte 95"/>
                <p:cNvSpPr txBox="1"/>
                <p:nvPr/>
              </p:nvSpPr>
              <p:spPr>
                <a:xfrm>
                  <a:off x="3816003" y="6732240"/>
                  <a:ext cx="717193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l-GR" sz="7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α</a:t>
                  </a:r>
                  <a:r>
                    <a:rPr lang="fr-BE" sz="7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-ORF149</a:t>
                  </a:r>
                  <a:endParaRPr lang="en-GB" sz="7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7" name="ZoneTexte 96"/>
                <p:cNvSpPr txBox="1"/>
                <p:nvPr/>
              </p:nvSpPr>
              <p:spPr>
                <a:xfrm>
                  <a:off x="3772704" y="7337467"/>
                  <a:ext cx="770500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GB" sz="7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Overlay/</a:t>
                  </a:r>
                  <a:r>
                    <a:rPr lang="en-GB" sz="700" b="1" dirty="0" err="1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Dapi</a:t>
                  </a:r>
                  <a:endParaRPr lang="en-GB" sz="7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02" name="Connecteur droit 101"/>
                <p:cNvCxnSpPr/>
                <p:nvPr/>
              </p:nvCxnSpPr>
              <p:spPr>
                <a:xfrm>
                  <a:off x="1284519" y="4282899"/>
                  <a:ext cx="0" cy="119880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3" name="Connecteur droit 102"/>
                <p:cNvCxnSpPr/>
                <p:nvPr/>
              </p:nvCxnSpPr>
              <p:spPr>
                <a:xfrm>
                  <a:off x="1284519" y="5527997"/>
                  <a:ext cx="0" cy="119880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4" name="Connecteur droit 103"/>
                <p:cNvCxnSpPr/>
                <p:nvPr/>
              </p:nvCxnSpPr>
              <p:spPr>
                <a:xfrm>
                  <a:off x="1284519" y="6773095"/>
                  <a:ext cx="0" cy="119880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5" name="Connecteur droit 104"/>
                <p:cNvCxnSpPr/>
                <p:nvPr/>
              </p:nvCxnSpPr>
              <p:spPr>
                <a:xfrm>
                  <a:off x="1284000" y="8061284"/>
                  <a:ext cx="0" cy="21600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04" name="Connecteur droit 303"/>
                <p:cNvCxnSpPr/>
                <p:nvPr/>
              </p:nvCxnSpPr>
              <p:spPr>
                <a:xfrm rot="16200000">
                  <a:off x="2067370" y="3504567"/>
                  <a:ext cx="0" cy="145800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05" name="Connecteur droit 304"/>
                <p:cNvCxnSpPr/>
                <p:nvPr/>
              </p:nvCxnSpPr>
              <p:spPr>
                <a:xfrm rot="16200000">
                  <a:off x="3725929" y="3503703"/>
                  <a:ext cx="0" cy="145800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06" name="Connecteur droit 305"/>
                <p:cNvCxnSpPr/>
                <p:nvPr/>
              </p:nvCxnSpPr>
              <p:spPr>
                <a:xfrm rot="16200000">
                  <a:off x="5388499" y="3502839"/>
                  <a:ext cx="0" cy="145800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06" name="ZoneTexte 205"/>
              <p:cNvSpPr txBox="1"/>
              <p:nvPr/>
            </p:nvSpPr>
            <p:spPr>
              <a:xfrm>
                <a:off x="3780000" y="2023204"/>
                <a:ext cx="1296144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algn="ctr">
                  <a:defRPr sz="1000" b="1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fr-BE" dirty="0"/>
                  <a:t>Inoculation of CCB </a:t>
                </a:r>
                <a:r>
                  <a:rPr lang="fr-BE" dirty="0" err="1"/>
                  <a:t>cells</a:t>
                </a:r>
                <a:endParaRPr lang="en-GB" dirty="0"/>
              </a:p>
            </p:txBody>
          </p:sp>
          <p:cxnSp>
            <p:nvCxnSpPr>
              <p:cNvPr id="223" name="Connecteur droit 222"/>
              <p:cNvCxnSpPr/>
              <p:nvPr/>
            </p:nvCxnSpPr>
            <p:spPr>
              <a:xfrm flipV="1">
                <a:off x="4103193" y="2665427"/>
                <a:ext cx="1969984" cy="424"/>
              </a:xfrm>
              <a:prstGeom prst="line">
                <a:avLst/>
              </a:prstGeom>
              <a:ln w="19050">
                <a:solidFill>
                  <a:schemeClr val="tx1"/>
                </a:solidFill>
                <a:headEnd type="none" w="med" len="med"/>
                <a:tailEnd type="arrow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2" name="Connecteur droit 231"/>
              <p:cNvCxnSpPr/>
              <p:nvPr/>
            </p:nvCxnSpPr>
            <p:spPr>
              <a:xfrm>
                <a:off x="4431524" y="2673051"/>
                <a:ext cx="1" cy="3600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33" name="ZoneTexte 232"/>
              <p:cNvSpPr txBox="1"/>
              <p:nvPr/>
            </p:nvSpPr>
            <p:spPr>
              <a:xfrm>
                <a:off x="4294720" y="2663033"/>
                <a:ext cx="27360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BE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en-GB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30" name="Connecteur droit 229"/>
              <p:cNvCxnSpPr/>
              <p:nvPr/>
            </p:nvCxnSpPr>
            <p:spPr>
              <a:xfrm>
                <a:off x="5416406" y="2673515"/>
                <a:ext cx="1" cy="3600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31" name="ZoneTexte 230"/>
              <p:cNvSpPr txBox="1"/>
              <p:nvPr/>
            </p:nvSpPr>
            <p:spPr>
              <a:xfrm>
                <a:off x="5182290" y="2663033"/>
                <a:ext cx="474595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BE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8</a:t>
                </a:r>
                <a:endParaRPr lang="en-GB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28" name="Connecteur droit 227"/>
              <p:cNvCxnSpPr/>
              <p:nvPr/>
            </p:nvCxnSpPr>
            <p:spPr>
              <a:xfrm>
                <a:off x="4923746" y="2673051"/>
                <a:ext cx="1" cy="3600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29" name="ZoneTexte 228"/>
              <p:cNvSpPr txBox="1"/>
              <p:nvPr/>
            </p:nvSpPr>
            <p:spPr>
              <a:xfrm>
                <a:off x="4690256" y="2663033"/>
                <a:ext cx="46381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BE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4</a:t>
                </a:r>
                <a:endParaRPr lang="en-GB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7" name="ZoneTexte 226"/>
              <p:cNvSpPr txBox="1"/>
              <p:nvPr/>
            </p:nvSpPr>
            <p:spPr>
              <a:xfrm>
                <a:off x="5400289" y="2188118"/>
                <a:ext cx="726595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lnSpc>
                    <a:spcPts val="1200"/>
                  </a:lnSpc>
                </a:pPr>
                <a:r>
                  <a:rPr lang="fr-BE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Time (</a:t>
                </a:r>
                <a:r>
                  <a:rPr lang="fr-BE" sz="10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hours</a:t>
                </a:r>
                <a:r>
                  <a:rPr lang="fr-BE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lang="en-GB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5" name="ZoneTexte 204"/>
              <p:cNvSpPr txBox="1"/>
              <p:nvPr/>
            </p:nvSpPr>
            <p:spPr>
              <a:xfrm>
                <a:off x="1216800" y="2065534"/>
                <a:ext cx="1224136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BE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o-transfection of CCB </a:t>
                </a:r>
                <a:r>
                  <a:rPr lang="fr-BE" sz="10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ells</a:t>
                </a:r>
                <a:endParaRPr lang="en-GB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7" name="ZoneTexte 206"/>
              <p:cNvSpPr txBox="1"/>
              <p:nvPr/>
            </p:nvSpPr>
            <p:spPr>
              <a:xfrm>
                <a:off x="347896" y="475928"/>
                <a:ext cx="936104" cy="400110"/>
              </a:xfrm>
              <a:prstGeom prst="rect">
                <a:avLst/>
              </a:prstGeom>
              <a:noFill/>
              <a:ln w="28575"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BE" sz="2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</a:p>
            </p:txBody>
          </p:sp>
          <p:grpSp>
            <p:nvGrpSpPr>
              <p:cNvPr id="208" name="Groupe 207"/>
              <p:cNvGrpSpPr/>
              <p:nvPr/>
            </p:nvGrpSpPr>
            <p:grpSpPr>
              <a:xfrm>
                <a:off x="906850" y="1007398"/>
                <a:ext cx="1589996" cy="786450"/>
                <a:chOff x="1259779" y="1232588"/>
                <a:chExt cx="1589996" cy="786450"/>
              </a:xfrm>
            </p:grpSpPr>
            <p:grpSp>
              <p:nvGrpSpPr>
                <p:cNvPr id="282" name="Groupe 281"/>
                <p:cNvGrpSpPr/>
                <p:nvPr/>
              </p:nvGrpSpPr>
              <p:grpSpPr>
                <a:xfrm>
                  <a:off x="1259779" y="1232588"/>
                  <a:ext cx="762745" cy="612236"/>
                  <a:chOff x="1259779" y="1232588"/>
                  <a:chExt cx="762745" cy="612236"/>
                </a:xfrm>
              </p:grpSpPr>
              <p:grpSp>
                <p:nvGrpSpPr>
                  <p:cNvPr id="286" name="Groupe 285"/>
                  <p:cNvGrpSpPr/>
                  <p:nvPr/>
                </p:nvGrpSpPr>
                <p:grpSpPr>
                  <a:xfrm>
                    <a:off x="1547664" y="1484784"/>
                    <a:ext cx="360040" cy="360040"/>
                    <a:chOff x="1547664" y="1484784"/>
                    <a:chExt cx="360040" cy="360040"/>
                  </a:xfrm>
                </p:grpSpPr>
                <p:sp>
                  <p:nvSpPr>
                    <p:cNvPr id="289" name="Ellipse 288"/>
                    <p:cNvSpPr/>
                    <p:nvPr/>
                  </p:nvSpPr>
                  <p:spPr>
                    <a:xfrm>
                      <a:off x="1547664" y="1484784"/>
                      <a:ext cx="360040" cy="360040"/>
                    </a:xfrm>
                    <a:prstGeom prst="ellipse">
                      <a:avLst/>
                    </a:prstGeom>
                    <a:noFill/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GB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90" name="Rectangle 289"/>
                    <p:cNvSpPr/>
                    <p:nvPr/>
                  </p:nvSpPr>
                  <p:spPr>
                    <a:xfrm rot="19192170">
                      <a:off x="1572210" y="1509832"/>
                      <a:ext cx="81714" cy="45719"/>
                    </a:xfrm>
                    <a:prstGeom prst="rect">
                      <a:avLst/>
                    </a:prstGeom>
                    <a:solidFill>
                      <a:schemeClr val="accent2">
                        <a:lumMod val="20000"/>
                        <a:lumOff val="80000"/>
                      </a:schemeClr>
                    </a:solidFill>
                    <a:ln w="12700">
                      <a:solidFill>
                        <a:srgbClr val="C00000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GB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91" name="Rectangle 290"/>
                    <p:cNvSpPr/>
                    <p:nvPr/>
                  </p:nvSpPr>
                  <p:spPr>
                    <a:xfrm rot="2876662">
                      <a:off x="1806467" y="1510390"/>
                      <a:ext cx="81714" cy="45719"/>
                    </a:xfrm>
                    <a:prstGeom prst="rect">
                      <a:avLst/>
                    </a:prstGeom>
                    <a:solidFill>
                      <a:schemeClr val="accent6">
                        <a:lumMod val="20000"/>
                        <a:lumOff val="80000"/>
                      </a:schemeClr>
                    </a:solidFill>
                    <a:ln w="12700">
                      <a:solidFill>
                        <a:schemeClr val="accent6">
                          <a:lumMod val="50000"/>
                        </a:schemeClr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GB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sp>
                <p:nvSpPr>
                  <p:cNvPr id="287" name="ZoneTexte 286"/>
                  <p:cNvSpPr txBox="1"/>
                  <p:nvPr/>
                </p:nvSpPr>
                <p:spPr>
                  <a:xfrm rot="19137150">
                    <a:off x="1259779" y="1374396"/>
                    <a:ext cx="586619" cy="20005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700" b="1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ORF112</a:t>
                    </a:r>
                  </a:p>
                </p:txBody>
              </p:sp>
              <p:sp>
                <p:nvSpPr>
                  <p:cNvPr id="288" name="ZoneTexte 287"/>
                  <p:cNvSpPr txBox="1"/>
                  <p:nvPr/>
                </p:nvSpPr>
                <p:spPr>
                  <a:xfrm rot="2847102">
                    <a:off x="1696217" y="1358840"/>
                    <a:ext cx="452560" cy="20005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fr-BE" sz="700" b="1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galK</a:t>
                    </a:r>
                    <a:endParaRPr lang="en-GB" sz="700" b="1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283" name="Rectangle à coins arrondis 282"/>
                <p:cNvSpPr/>
                <p:nvPr/>
              </p:nvSpPr>
              <p:spPr>
                <a:xfrm>
                  <a:off x="1701896" y="1812606"/>
                  <a:ext cx="67368" cy="45719"/>
                </a:xfrm>
                <a:prstGeom prst="roundRect">
                  <a:avLst/>
                </a:prstGeom>
                <a:solidFill>
                  <a:srgbClr val="006600"/>
                </a:solidFill>
                <a:ln>
                  <a:solidFill>
                    <a:srgbClr val="0066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84" name="ZoneTexte 283"/>
                <p:cNvSpPr txBox="1"/>
                <p:nvPr/>
              </p:nvSpPr>
              <p:spPr>
                <a:xfrm>
                  <a:off x="1465868" y="1818983"/>
                  <a:ext cx="508416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en-US"/>
                  </a:defPPr>
                  <a:lvl1pPr>
                    <a:defRPr sz="600" b="1"/>
                  </a:lvl1pPr>
                </a:lstStyle>
                <a:p>
                  <a:pPr algn="ctr"/>
                  <a:r>
                    <a:rPr lang="fr-BE" sz="7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GFP</a:t>
                  </a:r>
                  <a:endParaRPr lang="en-GB" sz="700" i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85" name="ZoneTexte 284"/>
                <p:cNvSpPr txBox="1"/>
                <p:nvPr/>
              </p:nvSpPr>
              <p:spPr>
                <a:xfrm>
                  <a:off x="2380220" y="1818983"/>
                  <a:ext cx="469555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en-US"/>
                  </a:defPPr>
                  <a:lvl1pPr>
                    <a:defRPr sz="600" b="1"/>
                  </a:lvl1pPr>
                </a:lstStyle>
                <a:p>
                  <a:pPr algn="ctr"/>
                  <a:r>
                    <a:rPr lang="fr-BE" sz="7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GFP</a:t>
                  </a:r>
                  <a:endParaRPr lang="en-GB" sz="700" i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09" name="Groupe 208"/>
              <p:cNvGrpSpPr/>
              <p:nvPr/>
            </p:nvGrpSpPr>
            <p:grpSpPr>
              <a:xfrm>
                <a:off x="1883813" y="975046"/>
                <a:ext cx="690870" cy="658273"/>
                <a:chOff x="1343038" y="1204049"/>
                <a:chExt cx="690870" cy="658273"/>
              </a:xfrm>
            </p:grpSpPr>
            <p:grpSp>
              <p:nvGrpSpPr>
                <p:cNvPr id="274" name="Groupe 273"/>
                <p:cNvGrpSpPr/>
                <p:nvPr/>
              </p:nvGrpSpPr>
              <p:grpSpPr>
                <a:xfrm>
                  <a:off x="1343038" y="1204049"/>
                  <a:ext cx="690870" cy="644994"/>
                  <a:chOff x="1343038" y="1204049"/>
                  <a:chExt cx="690870" cy="644994"/>
                </a:xfrm>
              </p:grpSpPr>
              <p:grpSp>
                <p:nvGrpSpPr>
                  <p:cNvPr id="276" name="Groupe 275"/>
                  <p:cNvGrpSpPr/>
                  <p:nvPr/>
                </p:nvGrpSpPr>
                <p:grpSpPr>
                  <a:xfrm>
                    <a:off x="1547664" y="1489003"/>
                    <a:ext cx="360040" cy="360040"/>
                    <a:chOff x="1547664" y="1489003"/>
                    <a:chExt cx="360040" cy="360040"/>
                  </a:xfrm>
                </p:grpSpPr>
                <p:sp>
                  <p:nvSpPr>
                    <p:cNvPr id="279" name="Ellipse 278"/>
                    <p:cNvSpPr/>
                    <p:nvPr/>
                  </p:nvSpPr>
                  <p:spPr>
                    <a:xfrm>
                      <a:off x="1547664" y="1489003"/>
                      <a:ext cx="360040" cy="360040"/>
                    </a:xfrm>
                    <a:prstGeom prst="ellipse">
                      <a:avLst/>
                    </a:prstGeom>
                    <a:noFill/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GB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80" name="Rectangle 279"/>
                    <p:cNvSpPr/>
                    <p:nvPr/>
                  </p:nvSpPr>
                  <p:spPr>
                    <a:xfrm rot="19192170">
                      <a:off x="1572210" y="1514203"/>
                      <a:ext cx="81714" cy="45719"/>
                    </a:xfrm>
                    <a:prstGeom prst="rect">
                      <a:avLst/>
                    </a:prstGeom>
                    <a:solidFill>
                      <a:schemeClr val="accent6">
                        <a:lumMod val="20000"/>
                        <a:lumOff val="80000"/>
                      </a:schemeClr>
                    </a:solidFill>
                    <a:ln w="12700">
                      <a:solidFill>
                        <a:schemeClr val="accent6">
                          <a:lumMod val="50000"/>
                        </a:schemeClr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GB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81" name="Rectangle 280"/>
                    <p:cNvSpPr/>
                    <p:nvPr/>
                  </p:nvSpPr>
                  <p:spPr>
                    <a:xfrm rot="2876662">
                      <a:off x="1806467" y="1514203"/>
                      <a:ext cx="81714" cy="45719"/>
                    </a:xfrm>
                    <a:prstGeom prst="rect">
                      <a:avLst/>
                    </a:prstGeom>
                    <a:solidFill>
                      <a:schemeClr val="accent4">
                        <a:lumMod val="20000"/>
                        <a:lumOff val="80000"/>
                      </a:schemeClr>
                    </a:solidFill>
                    <a:ln w="12700">
                      <a:solidFill>
                        <a:srgbClr val="CC00CC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GB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sp>
                <p:nvSpPr>
                  <p:cNvPr id="277" name="ZoneTexte 276"/>
                  <p:cNvSpPr txBox="1"/>
                  <p:nvPr/>
                </p:nvSpPr>
                <p:spPr>
                  <a:xfrm rot="19063149">
                    <a:off x="1343038" y="1363003"/>
                    <a:ext cx="402769" cy="20005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fr-BE" sz="700" b="1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galK</a:t>
                    </a:r>
                    <a:endParaRPr lang="en-GB" sz="700" b="1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78" name="ZoneTexte 277"/>
                  <p:cNvSpPr txBox="1"/>
                  <p:nvPr/>
                </p:nvSpPr>
                <p:spPr>
                  <a:xfrm rot="3017857">
                    <a:off x="1631969" y="1405933"/>
                    <a:ext cx="603824" cy="20005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700" b="1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ORF149</a:t>
                    </a:r>
                  </a:p>
                </p:txBody>
              </p:sp>
            </p:grpSp>
            <p:sp>
              <p:nvSpPr>
                <p:cNvPr id="275" name="Rectangle à coins arrondis 274"/>
                <p:cNvSpPr/>
                <p:nvPr/>
              </p:nvSpPr>
              <p:spPr>
                <a:xfrm>
                  <a:off x="1701896" y="1816603"/>
                  <a:ext cx="67368" cy="45719"/>
                </a:xfrm>
                <a:prstGeom prst="roundRect">
                  <a:avLst/>
                </a:prstGeom>
                <a:solidFill>
                  <a:srgbClr val="006600"/>
                </a:solidFill>
                <a:ln>
                  <a:solidFill>
                    <a:srgbClr val="0066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10" name="Groupe 209"/>
              <p:cNvGrpSpPr/>
              <p:nvPr/>
            </p:nvGrpSpPr>
            <p:grpSpPr>
              <a:xfrm>
                <a:off x="999237" y="755605"/>
                <a:ext cx="296463" cy="455745"/>
                <a:chOff x="2469303" y="3626370"/>
                <a:chExt cx="296463" cy="455745"/>
              </a:xfrm>
            </p:grpSpPr>
            <p:grpSp>
              <p:nvGrpSpPr>
                <p:cNvPr id="257" name="Groupe 256"/>
                <p:cNvGrpSpPr/>
                <p:nvPr/>
              </p:nvGrpSpPr>
              <p:grpSpPr>
                <a:xfrm rot="19497353">
                  <a:off x="2469303" y="3870110"/>
                  <a:ext cx="183720" cy="212005"/>
                  <a:chOff x="1522800" y="2545200"/>
                  <a:chExt cx="244632" cy="212005"/>
                </a:xfrm>
              </p:grpSpPr>
              <p:cxnSp>
                <p:nvCxnSpPr>
                  <p:cNvPr id="267" name="Connecteur droit 266"/>
                  <p:cNvCxnSpPr/>
                  <p:nvPr/>
                </p:nvCxnSpPr>
                <p:spPr>
                  <a:xfrm>
                    <a:off x="1663200" y="2545200"/>
                    <a:ext cx="0" cy="144955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grpSp>
                <p:nvGrpSpPr>
                  <p:cNvPr id="268" name="Groupe 267"/>
                  <p:cNvGrpSpPr/>
                  <p:nvPr/>
                </p:nvGrpSpPr>
                <p:grpSpPr>
                  <a:xfrm>
                    <a:off x="1522800" y="2545200"/>
                    <a:ext cx="244632" cy="212005"/>
                    <a:chOff x="1522800" y="2545200"/>
                    <a:chExt cx="244632" cy="212005"/>
                  </a:xfrm>
                </p:grpSpPr>
                <p:cxnSp>
                  <p:nvCxnSpPr>
                    <p:cNvPr id="269" name="Connecteur droit 268"/>
                    <p:cNvCxnSpPr/>
                    <p:nvPr/>
                  </p:nvCxnSpPr>
                  <p:spPr>
                    <a:xfrm>
                      <a:off x="1628800" y="2545200"/>
                      <a:ext cx="0" cy="144955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70" name="Connecteur droit 269"/>
                    <p:cNvCxnSpPr/>
                    <p:nvPr/>
                  </p:nvCxnSpPr>
                  <p:spPr>
                    <a:xfrm flipH="1">
                      <a:off x="1548408" y="2684728"/>
                      <a:ext cx="80392" cy="72477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71" name="Connecteur droit 270"/>
                    <p:cNvCxnSpPr/>
                    <p:nvPr/>
                  </p:nvCxnSpPr>
                  <p:spPr>
                    <a:xfrm>
                      <a:off x="1663200" y="2684728"/>
                      <a:ext cx="79200" cy="72000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72" name="Connecteur droit 271"/>
                    <p:cNvCxnSpPr/>
                    <p:nvPr/>
                  </p:nvCxnSpPr>
                  <p:spPr>
                    <a:xfrm>
                      <a:off x="1688232" y="2656354"/>
                      <a:ext cx="79200" cy="72000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73" name="Connecteur droit 272"/>
                    <p:cNvCxnSpPr/>
                    <p:nvPr/>
                  </p:nvCxnSpPr>
                  <p:spPr>
                    <a:xfrm flipH="1">
                      <a:off x="1522800" y="2656115"/>
                      <a:ext cx="80392" cy="72477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  <p:grpSp>
              <p:nvGrpSpPr>
                <p:cNvPr id="258" name="Groupe 257"/>
                <p:cNvGrpSpPr/>
                <p:nvPr/>
              </p:nvGrpSpPr>
              <p:grpSpPr>
                <a:xfrm rot="1905625">
                  <a:off x="2520139" y="3707369"/>
                  <a:ext cx="183720" cy="212005"/>
                  <a:chOff x="1522800" y="2545200"/>
                  <a:chExt cx="244632" cy="212005"/>
                </a:xfrm>
              </p:grpSpPr>
              <p:cxnSp>
                <p:nvCxnSpPr>
                  <p:cNvPr id="260" name="Connecteur droit 259"/>
                  <p:cNvCxnSpPr/>
                  <p:nvPr/>
                </p:nvCxnSpPr>
                <p:spPr>
                  <a:xfrm>
                    <a:off x="1663200" y="2545200"/>
                    <a:ext cx="0" cy="144955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grpSp>
                <p:nvGrpSpPr>
                  <p:cNvPr id="261" name="Groupe 260"/>
                  <p:cNvGrpSpPr/>
                  <p:nvPr/>
                </p:nvGrpSpPr>
                <p:grpSpPr>
                  <a:xfrm>
                    <a:off x="1522800" y="2545200"/>
                    <a:ext cx="244632" cy="212005"/>
                    <a:chOff x="1522800" y="2545200"/>
                    <a:chExt cx="244632" cy="212005"/>
                  </a:xfrm>
                </p:grpSpPr>
                <p:cxnSp>
                  <p:nvCxnSpPr>
                    <p:cNvPr id="262" name="Connecteur droit 261"/>
                    <p:cNvCxnSpPr/>
                    <p:nvPr/>
                  </p:nvCxnSpPr>
                  <p:spPr>
                    <a:xfrm>
                      <a:off x="1628800" y="2545200"/>
                      <a:ext cx="0" cy="144955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63" name="Connecteur droit 262"/>
                    <p:cNvCxnSpPr/>
                    <p:nvPr/>
                  </p:nvCxnSpPr>
                  <p:spPr>
                    <a:xfrm flipH="1">
                      <a:off x="1548408" y="2684728"/>
                      <a:ext cx="80392" cy="72477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64" name="Connecteur droit 263"/>
                    <p:cNvCxnSpPr/>
                    <p:nvPr/>
                  </p:nvCxnSpPr>
                  <p:spPr>
                    <a:xfrm>
                      <a:off x="1663200" y="2684728"/>
                      <a:ext cx="79200" cy="72000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65" name="Connecteur droit 264"/>
                    <p:cNvCxnSpPr/>
                    <p:nvPr/>
                  </p:nvCxnSpPr>
                  <p:spPr>
                    <a:xfrm>
                      <a:off x="1688232" y="2656354"/>
                      <a:ext cx="79200" cy="72000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66" name="Connecteur droit 265"/>
                    <p:cNvCxnSpPr/>
                    <p:nvPr/>
                  </p:nvCxnSpPr>
                  <p:spPr>
                    <a:xfrm flipH="1">
                      <a:off x="1522800" y="2656115"/>
                      <a:ext cx="80392" cy="72477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  <p:sp>
              <p:nvSpPr>
                <p:cNvPr id="259" name="Explosion 1 258"/>
                <p:cNvSpPr/>
                <p:nvPr/>
              </p:nvSpPr>
              <p:spPr>
                <a:xfrm>
                  <a:off x="2621766" y="3626370"/>
                  <a:ext cx="144000" cy="144000"/>
                </a:xfrm>
                <a:prstGeom prst="irregularSeal1">
                  <a:avLst/>
                </a:prstGeom>
                <a:solidFill>
                  <a:srgbClr val="C00000"/>
                </a:solidFill>
                <a:ln w="3175">
                  <a:solidFill>
                    <a:srgbClr val="C000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11" name="Groupe 210"/>
              <p:cNvGrpSpPr/>
              <p:nvPr/>
            </p:nvGrpSpPr>
            <p:grpSpPr>
              <a:xfrm>
                <a:off x="2443106" y="755576"/>
                <a:ext cx="232712" cy="437322"/>
                <a:chOff x="3700344" y="3672808"/>
                <a:chExt cx="232712" cy="437322"/>
              </a:xfrm>
            </p:grpSpPr>
            <p:grpSp>
              <p:nvGrpSpPr>
                <p:cNvPr id="240" name="Groupe 239"/>
                <p:cNvGrpSpPr/>
                <p:nvPr/>
              </p:nvGrpSpPr>
              <p:grpSpPr>
                <a:xfrm rot="2498965">
                  <a:off x="3749336" y="3898125"/>
                  <a:ext cx="183720" cy="212005"/>
                  <a:chOff x="1522800" y="2545200"/>
                  <a:chExt cx="244632" cy="212005"/>
                </a:xfrm>
              </p:grpSpPr>
              <p:cxnSp>
                <p:nvCxnSpPr>
                  <p:cNvPr id="250" name="Connecteur droit 249"/>
                  <p:cNvCxnSpPr/>
                  <p:nvPr/>
                </p:nvCxnSpPr>
                <p:spPr>
                  <a:xfrm>
                    <a:off x="1663200" y="2545200"/>
                    <a:ext cx="0" cy="144955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grpSp>
                <p:nvGrpSpPr>
                  <p:cNvPr id="251" name="Groupe 250"/>
                  <p:cNvGrpSpPr/>
                  <p:nvPr/>
                </p:nvGrpSpPr>
                <p:grpSpPr>
                  <a:xfrm>
                    <a:off x="1522800" y="2545200"/>
                    <a:ext cx="244632" cy="212005"/>
                    <a:chOff x="1522800" y="2545200"/>
                    <a:chExt cx="244632" cy="212005"/>
                  </a:xfrm>
                </p:grpSpPr>
                <p:cxnSp>
                  <p:nvCxnSpPr>
                    <p:cNvPr id="252" name="Connecteur droit 251"/>
                    <p:cNvCxnSpPr/>
                    <p:nvPr/>
                  </p:nvCxnSpPr>
                  <p:spPr>
                    <a:xfrm>
                      <a:off x="1628800" y="2545200"/>
                      <a:ext cx="0" cy="144955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53" name="Connecteur droit 252"/>
                    <p:cNvCxnSpPr/>
                    <p:nvPr/>
                  </p:nvCxnSpPr>
                  <p:spPr>
                    <a:xfrm flipH="1">
                      <a:off x="1548408" y="2684728"/>
                      <a:ext cx="80392" cy="72477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54" name="Connecteur droit 253"/>
                    <p:cNvCxnSpPr/>
                    <p:nvPr/>
                  </p:nvCxnSpPr>
                  <p:spPr>
                    <a:xfrm>
                      <a:off x="1663200" y="2684728"/>
                      <a:ext cx="79200" cy="72000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55" name="Connecteur droit 254"/>
                    <p:cNvCxnSpPr/>
                    <p:nvPr/>
                  </p:nvCxnSpPr>
                  <p:spPr>
                    <a:xfrm>
                      <a:off x="1688232" y="2656354"/>
                      <a:ext cx="79200" cy="72000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56" name="Connecteur droit 255"/>
                    <p:cNvCxnSpPr/>
                    <p:nvPr/>
                  </p:nvCxnSpPr>
                  <p:spPr>
                    <a:xfrm flipH="1">
                      <a:off x="1522800" y="2656115"/>
                      <a:ext cx="80392" cy="72477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  <p:grpSp>
              <p:nvGrpSpPr>
                <p:cNvPr id="241" name="Groupe 240"/>
                <p:cNvGrpSpPr/>
                <p:nvPr/>
              </p:nvGrpSpPr>
              <p:grpSpPr>
                <a:xfrm rot="20109146">
                  <a:off x="3717121" y="3736468"/>
                  <a:ext cx="183720" cy="212005"/>
                  <a:chOff x="1522800" y="2545200"/>
                  <a:chExt cx="244632" cy="212005"/>
                </a:xfrm>
              </p:grpSpPr>
              <p:cxnSp>
                <p:nvCxnSpPr>
                  <p:cNvPr id="243" name="Connecteur droit 242"/>
                  <p:cNvCxnSpPr/>
                  <p:nvPr/>
                </p:nvCxnSpPr>
                <p:spPr>
                  <a:xfrm>
                    <a:off x="1663200" y="2545200"/>
                    <a:ext cx="0" cy="144955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grpSp>
                <p:nvGrpSpPr>
                  <p:cNvPr id="244" name="Groupe 243"/>
                  <p:cNvGrpSpPr/>
                  <p:nvPr/>
                </p:nvGrpSpPr>
                <p:grpSpPr>
                  <a:xfrm>
                    <a:off x="1522800" y="2545200"/>
                    <a:ext cx="244632" cy="212005"/>
                    <a:chOff x="1522800" y="2545200"/>
                    <a:chExt cx="244632" cy="212005"/>
                  </a:xfrm>
                </p:grpSpPr>
                <p:cxnSp>
                  <p:nvCxnSpPr>
                    <p:cNvPr id="245" name="Connecteur droit 244"/>
                    <p:cNvCxnSpPr/>
                    <p:nvPr/>
                  </p:nvCxnSpPr>
                  <p:spPr>
                    <a:xfrm>
                      <a:off x="1628800" y="2545200"/>
                      <a:ext cx="0" cy="144955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46" name="Connecteur droit 245"/>
                    <p:cNvCxnSpPr/>
                    <p:nvPr/>
                  </p:nvCxnSpPr>
                  <p:spPr>
                    <a:xfrm flipH="1">
                      <a:off x="1548408" y="2684728"/>
                      <a:ext cx="80392" cy="72477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47" name="Connecteur droit 246"/>
                    <p:cNvCxnSpPr/>
                    <p:nvPr/>
                  </p:nvCxnSpPr>
                  <p:spPr>
                    <a:xfrm>
                      <a:off x="1663200" y="2684728"/>
                      <a:ext cx="79200" cy="72000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48" name="Connecteur droit 247"/>
                    <p:cNvCxnSpPr/>
                    <p:nvPr/>
                  </p:nvCxnSpPr>
                  <p:spPr>
                    <a:xfrm>
                      <a:off x="1688232" y="2656354"/>
                      <a:ext cx="79200" cy="72000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49" name="Connecteur droit 248"/>
                    <p:cNvCxnSpPr/>
                    <p:nvPr/>
                  </p:nvCxnSpPr>
                  <p:spPr>
                    <a:xfrm flipH="1">
                      <a:off x="1522800" y="2656115"/>
                      <a:ext cx="80392" cy="72477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  <p:sp>
              <p:nvSpPr>
                <p:cNvPr id="242" name="Explosion 1 241"/>
                <p:cNvSpPr/>
                <p:nvPr/>
              </p:nvSpPr>
              <p:spPr>
                <a:xfrm>
                  <a:off x="3700344" y="3672808"/>
                  <a:ext cx="144000" cy="144000"/>
                </a:xfrm>
                <a:prstGeom prst="irregularSeal1">
                  <a:avLst/>
                </a:prstGeom>
                <a:solidFill>
                  <a:srgbClr val="FF00FF"/>
                </a:solidFill>
                <a:ln w="3175">
                  <a:solidFill>
                    <a:srgbClr val="FF00FF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12" name="ZoneTexte 211"/>
              <p:cNvSpPr txBox="1"/>
              <p:nvPr/>
            </p:nvSpPr>
            <p:spPr>
              <a:xfrm>
                <a:off x="1670371" y="1239954"/>
                <a:ext cx="31931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BE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213" name="ZoneTexte 212"/>
              <p:cNvSpPr txBox="1"/>
              <p:nvPr/>
            </p:nvSpPr>
            <p:spPr>
              <a:xfrm>
                <a:off x="902063" y="1736130"/>
                <a:ext cx="963401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>
                  <a:defRPr sz="600" b="1"/>
                </a:lvl1pPr>
              </a:lstStyle>
              <a:p>
                <a:pPr algn="ctr"/>
                <a:r>
                  <a:rPr lang="fr-BE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yHV-3 BAC ORF149 KO</a:t>
                </a:r>
                <a:endParaRPr lang="en-GB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4" name="ZoneTexte 213"/>
              <p:cNvSpPr txBox="1"/>
              <p:nvPr/>
            </p:nvSpPr>
            <p:spPr>
              <a:xfrm>
                <a:off x="1799845" y="1736130"/>
                <a:ext cx="963401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>
                  <a:defRPr sz="600" b="1"/>
                </a:lvl1pPr>
              </a:lstStyle>
              <a:p>
                <a:pPr algn="ctr"/>
                <a:r>
                  <a:rPr lang="fr-BE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yHV-3 BAC ORF112 KO</a:t>
                </a:r>
                <a:endParaRPr lang="en-GB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15" name="Connecteur droit 214"/>
              <p:cNvCxnSpPr/>
              <p:nvPr/>
            </p:nvCxnSpPr>
            <p:spPr>
              <a:xfrm>
                <a:off x="1016017" y="2071829"/>
                <a:ext cx="1626035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9" name="Connecteur droit 218"/>
              <p:cNvCxnSpPr/>
              <p:nvPr/>
            </p:nvCxnSpPr>
            <p:spPr>
              <a:xfrm>
                <a:off x="1504152" y="2665427"/>
                <a:ext cx="2188871" cy="0"/>
              </a:xfrm>
              <a:prstGeom prst="line">
                <a:avLst/>
              </a:prstGeom>
              <a:ln w="19050">
                <a:solidFill>
                  <a:schemeClr val="tx1"/>
                </a:solidFill>
                <a:headEnd type="none" w="med" len="med"/>
                <a:tailEnd type="arrow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8" name="Connecteur droit 237"/>
              <p:cNvCxnSpPr/>
              <p:nvPr/>
            </p:nvCxnSpPr>
            <p:spPr>
              <a:xfrm>
                <a:off x="1832483" y="2674490"/>
                <a:ext cx="1" cy="3600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39" name="ZoneTexte 238"/>
              <p:cNvSpPr txBox="1"/>
              <p:nvPr/>
            </p:nvSpPr>
            <p:spPr>
              <a:xfrm>
                <a:off x="1695679" y="2664008"/>
                <a:ext cx="27360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BE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en-GB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36" name="Connecteur droit 235"/>
              <p:cNvCxnSpPr/>
              <p:nvPr/>
            </p:nvCxnSpPr>
            <p:spPr>
              <a:xfrm>
                <a:off x="2817365" y="2673091"/>
                <a:ext cx="1" cy="3600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37" name="ZoneTexte 236"/>
              <p:cNvSpPr txBox="1"/>
              <p:nvPr/>
            </p:nvSpPr>
            <p:spPr>
              <a:xfrm>
                <a:off x="2608745" y="2664008"/>
                <a:ext cx="41353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algn="ctr">
                  <a:defRPr sz="1200" b="1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fr-BE" sz="1400" dirty="0"/>
                  <a:t>48</a:t>
                </a:r>
                <a:endParaRPr lang="en-GB" sz="1400" dirty="0"/>
              </a:p>
            </p:txBody>
          </p:sp>
          <p:cxnSp>
            <p:nvCxnSpPr>
              <p:cNvPr id="234" name="Connecteur droit 233"/>
              <p:cNvCxnSpPr/>
              <p:nvPr/>
            </p:nvCxnSpPr>
            <p:spPr>
              <a:xfrm>
                <a:off x="3309697" y="2673091"/>
                <a:ext cx="1" cy="3600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35" name="ZoneTexte 234"/>
              <p:cNvSpPr txBox="1"/>
              <p:nvPr/>
            </p:nvSpPr>
            <p:spPr>
              <a:xfrm>
                <a:off x="3082622" y="2664008"/>
                <a:ext cx="44723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BE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72</a:t>
                </a:r>
                <a:endParaRPr lang="en-GB" sz="1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17" name="Connecteur droit avec flèche 216"/>
              <p:cNvCxnSpPr/>
              <p:nvPr/>
            </p:nvCxnSpPr>
            <p:spPr>
              <a:xfrm>
                <a:off x="1829614" y="2428523"/>
                <a:ext cx="0" cy="180000"/>
              </a:xfrm>
              <a:prstGeom prst="straightConnector1">
                <a:avLst/>
              </a:prstGeom>
              <a:ln w="381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7" name="Connecteur droit avec flèche 296"/>
              <p:cNvCxnSpPr/>
              <p:nvPr/>
            </p:nvCxnSpPr>
            <p:spPr>
              <a:xfrm flipV="1">
                <a:off x="3309505" y="1690901"/>
                <a:ext cx="0" cy="900000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8" name="Connecteur droit avec flèche 217"/>
              <p:cNvCxnSpPr/>
              <p:nvPr/>
            </p:nvCxnSpPr>
            <p:spPr>
              <a:xfrm>
                <a:off x="4428149" y="2431825"/>
                <a:ext cx="0" cy="180000"/>
              </a:xfrm>
              <a:prstGeom prst="straightConnector1">
                <a:avLst/>
              </a:prstGeom>
              <a:ln w="381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96" name="ZoneTexte 295"/>
              <p:cNvSpPr txBox="1"/>
              <p:nvPr/>
            </p:nvSpPr>
            <p:spPr>
              <a:xfrm>
                <a:off x="2664000" y="1276122"/>
                <a:ext cx="1296144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algn="ctr">
                  <a:defRPr sz="1000" b="1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fr-BE" dirty="0" err="1"/>
                  <a:t>Harvesting</a:t>
                </a:r>
                <a:r>
                  <a:rPr lang="fr-BE" dirty="0"/>
                  <a:t> of </a:t>
                </a:r>
                <a:r>
                  <a:rPr lang="fr-BE" dirty="0" err="1"/>
                  <a:t>cell</a:t>
                </a:r>
                <a:r>
                  <a:rPr lang="fr-BE" dirty="0"/>
                  <a:t> </a:t>
                </a:r>
                <a:r>
                  <a:rPr lang="fr-BE" dirty="0" err="1"/>
                  <a:t>supernatant</a:t>
                </a:r>
                <a:endParaRPr lang="en-GB" dirty="0"/>
              </a:p>
            </p:txBody>
          </p:sp>
          <p:grpSp>
            <p:nvGrpSpPr>
              <p:cNvPr id="303" name="Groupe 302"/>
              <p:cNvGrpSpPr/>
              <p:nvPr/>
            </p:nvGrpSpPr>
            <p:grpSpPr>
              <a:xfrm>
                <a:off x="3995713" y="1477921"/>
                <a:ext cx="432436" cy="540000"/>
                <a:chOff x="3995713" y="1630336"/>
                <a:chExt cx="432436" cy="540000"/>
              </a:xfrm>
            </p:grpSpPr>
            <p:cxnSp>
              <p:nvCxnSpPr>
                <p:cNvPr id="301" name="Connecteur droit avec flèche 300"/>
                <p:cNvCxnSpPr/>
                <p:nvPr/>
              </p:nvCxnSpPr>
              <p:spPr>
                <a:xfrm>
                  <a:off x="4428149" y="1630336"/>
                  <a:ext cx="0" cy="540000"/>
                </a:xfrm>
                <a:prstGeom prst="straightConnector1">
                  <a:avLst/>
                </a:prstGeom>
                <a:ln w="28575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02" name="Connecteur droit avec flèche 301"/>
                <p:cNvCxnSpPr/>
                <p:nvPr/>
              </p:nvCxnSpPr>
              <p:spPr>
                <a:xfrm rot="16200000">
                  <a:off x="4211713" y="1428538"/>
                  <a:ext cx="0" cy="432000"/>
                </a:xfrm>
                <a:prstGeom prst="straightConnector1">
                  <a:avLst/>
                </a:prstGeom>
                <a:ln w="28575">
                  <a:solidFill>
                    <a:schemeClr val="tx1"/>
                  </a:solidFill>
                  <a:headEnd type="none" w="med" len="med"/>
                  <a:tailEnd type="none" w="med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02" name="ZoneTexte 201"/>
              <p:cNvSpPr txBox="1"/>
              <p:nvPr/>
            </p:nvSpPr>
            <p:spPr>
              <a:xfrm>
                <a:off x="1666253" y="3110997"/>
                <a:ext cx="1659656" cy="40011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BE" sz="10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Immunophenotyping</a:t>
                </a:r>
                <a:r>
                  <a:rPr lang="fr-BE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of </a:t>
                </a:r>
                <a:r>
                  <a:rPr lang="fr-BE" sz="10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transfected</a:t>
                </a:r>
                <a:r>
                  <a:rPr lang="fr-BE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fr-BE" sz="10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ells</a:t>
                </a:r>
                <a:endParaRPr lang="en-GB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3" name="ZoneTexte 202"/>
              <p:cNvSpPr txBox="1"/>
              <p:nvPr/>
            </p:nvSpPr>
            <p:spPr>
              <a:xfrm>
                <a:off x="3645024" y="3168715"/>
                <a:ext cx="2520280" cy="24622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BE" sz="10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Immunophenotyping</a:t>
                </a:r>
                <a:r>
                  <a:rPr lang="fr-BE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of </a:t>
                </a:r>
                <a:r>
                  <a:rPr lang="fr-BE" sz="10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infected</a:t>
                </a:r>
                <a:r>
                  <a:rPr lang="fr-BE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fr-BE" sz="10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ells</a:t>
                </a:r>
                <a:endParaRPr lang="en-GB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10" name="Connecteur droit avec flèche 309"/>
              <p:cNvCxnSpPr/>
              <p:nvPr/>
            </p:nvCxnSpPr>
            <p:spPr>
              <a:xfrm>
                <a:off x="2190570" y="3674514"/>
                <a:ext cx="0" cy="25200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prstDash val="sysDot"/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1" name="Connecteur droit avec flèche 310"/>
              <p:cNvCxnSpPr/>
              <p:nvPr/>
            </p:nvCxnSpPr>
            <p:spPr>
              <a:xfrm>
                <a:off x="3852540" y="3674514"/>
                <a:ext cx="0" cy="25200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prstDash val="sysDot"/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2" name="Connecteur droit avec flèche 311"/>
              <p:cNvCxnSpPr/>
              <p:nvPr/>
            </p:nvCxnSpPr>
            <p:spPr>
              <a:xfrm>
                <a:off x="5514510" y="3674514"/>
                <a:ext cx="0" cy="25200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prstDash val="sysDot"/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3" name="Connecteur droit avec flèche 312"/>
              <p:cNvCxnSpPr/>
              <p:nvPr/>
            </p:nvCxnSpPr>
            <p:spPr>
              <a:xfrm>
                <a:off x="2819220" y="2896766"/>
                <a:ext cx="0" cy="130909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prstDash val="sysDot"/>
                <a:headEnd type="none" w="med" len="med"/>
                <a:tailEnd type="non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4" name="Connecteur droit avec flèche 313"/>
              <p:cNvCxnSpPr/>
              <p:nvPr/>
            </p:nvCxnSpPr>
            <p:spPr>
              <a:xfrm>
                <a:off x="4919960" y="2896766"/>
                <a:ext cx="0" cy="130909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prstDash val="sysDot"/>
                <a:headEnd type="none" w="med" len="med"/>
                <a:tailEnd type="non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5" name="Connecteur droit avec flèche 314"/>
              <p:cNvCxnSpPr/>
              <p:nvPr/>
            </p:nvCxnSpPr>
            <p:spPr>
              <a:xfrm>
                <a:off x="5425610" y="2896766"/>
                <a:ext cx="0" cy="130909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prstDash val="sysDot"/>
                <a:headEnd type="none" w="med" len="med"/>
                <a:tailEnd type="non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09" name="ZoneTexte 308">
              <a:extLst>
                <a:ext uri="{FF2B5EF4-FFF2-40B4-BE49-F238E27FC236}">
                  <a16:creationId xmlns:a16="http://schemas.microsoft.com/office/drawing/2014/main" id="{2F831A9B-0B5B-47AB-A27D-0C97DB33106E}"/>
                </a:ext>
              </a:extLst>
            </p:cNvPr>
            <p:cNvSpPr txBox="1"/>
            <p:nvPr/>
          </p:nvSpPr>
          <p:spPr>
            <a:xfrm>
              <a:off x="3774575" y="4025962"/>
              <a:ext cx="28800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’</a:t>
              </a:r>
            </a:p>
          </p:txBody>
        </p:sp>
        <p:sp>
          <p:nvSpPr>
            <p:cNvPr id="318" name="ZoneTexte 317">
              <a:extLst>
                <a:ext uri="{FF2B5EF4-FFF2-40B4-BE49-F238E27FC236}">
                  <a16:creationId xmlns:a16="http://schemas.microsoft.com/office/drawing/2014/main" id="{91395F10-CAFB-47FB-86C9-A850B197155A}"/>
                </a:ext>
              </a:extLst>
            </p:cNvPr>
            <p:cNvSpPr txBox="1"/>
            <p:nvPr/>
          </p:nvSpPr>
          <p:spPr>
            <a:xfrm>
              <a:off x="3774575" y="4630453"/>
              <a:ext cx="28800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’</a:t>
              </a:r>
            </a:p>
          </p:txBody>
        </p:sp>
        <p:sp>
          <p:nvSpPr>
            <p:cNvPr id="322" name="ZoneTexte 321">
              <a:extLst>
                <a:ext uri="{FF2B5EF4-FFF2-40B4-BE49-F238E27FC236}">
                  <a16:creationId xmlns:a16="http://schemas.microsoft.com/office/drawing/2014/main" id="{51E2A2F4-3AAD-4FB7-B615-D177FACB2519}"/>
                </a:ext>
              </a:extLst>
            </p:cNvPr>
            <p:cNvSpPr txBox="1"/>
            <p:nvPr/>
          </p:nvSpPr>
          <p:spPr>
            <a:xfrm>
              <a:off x="3780160" y="5260014"/>
              <a:ext cx="28800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’</a:t>
              </a:r>
            </a:p>
          </p:txBody>
        </p:sp>
        <p:sp>
          <p:nvSpPr>
            <p:cNvPr id="324" name="ZoneTexte 323">
              <a:extLst>
                <a:ext uri="{FF2B5EF4-FFF2-40B4-BE49-F238E27FC236}">
                  <a16:creationId xmlns:a16="http://schemas.microsoft.com/office/drawing/2014/main" id="{7273D055-AE1E-4739-8D52-E9D605EEA993}"/>
                </a:ext>
              </a:extLst>
            </p:cNvPr>
            <p:cNvSpPr txBox="1"/>
            <p:nvPr/>
          </p:nvSpPr>
          <p:spPr>
            <a:xfrm>
              <a:off x="3773109" y="5871047"/>
              <a:ext cx="28800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’</a:t>
              </a:r>
            </a:p>
          </p:txBody>
        </p:sp>
        <p:sp>
          <p:nvSpPr>
            <p:cNvPr id="326" name="ZoneTexte 325">
              <a:extLst>
                <a:ext uri="{FF2B5EF4-FFF2-40B4-BE49-F238E27FC236}">
                  <a16:creationId xmlns:a16="http://schemas.microsoft.com/office/drawing/2014/main" id="{D39B6445-7E20-4298-8712-6CF10E42E19B}"/>
                </a:ext>
              </a:extLst>
            </p:cNvPr>
            <p:cNvSpPr txBox="1"/>
            <p:nvPr/>
          </p:nvSpPr>
          <p:spPr>
            <a:xfrm>
              <a:off x="3774418" y="6505988"/>
              <a:ext cx="28800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j’</a:t>
              </a:r>
            </a:p>
          </p:txBody>
        </p:sp>
        <p:sp>
          <p:nvSpPr>
            <p:cNvPr id="328" name="ZoneTexte 327">
              <a:extLst>
                <a:ext uri="{FF2B5EF4-FFF2-40B4-BE49-F238E27FC236}">
                  <a16:creationId xmlns:a16="http://schemas.microsoft.com/office/drawing/2014/main" id="{8CAA5C19-3E66-4C83-BCB9-53110192B427}"/>
                </a:ext>
              </a:extLst>
            </p:cNvPr>
            <p:cNvSpPr txBox="1"/>
            <p:nvPr/>
          </p:nvSpPr>
          <p:spPr>
            <a:xfrm>
              <a:off x="3769709" y="7112151"/>
              <a:ext cx="28800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’</a:t>
              </a:r>
            </a:p>
          </p:txBody>
        </p:sp>
        <p:sp>
          <p:nvSpPr>
            <p:cNvPr id="292" name="ZoneTexte 291"/>
            <p:cNvSpPr txBox="1"/>
            <p:nvPr/>
          </p:nvSpPr>
          <p:spPr>
            <a:xfrm>
              <a:off x="2132856" y="4958089"/>
              <a:ext cx="42223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BE" sz="8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71%</a:t>
              </a:r>
              <a:endParaRPr lang="en-GB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3" name="ZoneTexte 292"/>
            <p:cNvSpPr txBox="1"/>
            <p:nvPr/>
          </p:nvSpPr>
          <p:spPr>
            <a:xfrm>
              <a:off x="2134800" y="6198850"/>
              <a:ext cx="42223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BE" sz="8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15%</a:t>
              </a:r>
              <a:endParaRPr lang="en-GB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4" name="ZoneTexte 293"/>
            <p:cNvSpPr txBox="1"/>
            <p:nvPr/>
          </p:nvSpPr>
          <p:spPr>
            <a:xfrm>
              <a:off x="2134800" y="7448050"/>
              <a:ext cx="42223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BE" sz="8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14%</a:t>
              </a:r>
              <a:endParaRPr lang="en-GB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5" name="ZoneTexte 294"/>
            <p:cNvSpPr txBox="1"/>
            <p:nvPr/>
          </p:nvSpPr>
          <p:spPr>
            <a:xfrm>
              <a:off x="3798850" y="4957489"/>
              <a:ext cx="42223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BE" sz="8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75%</a:t>
              </a:r>
              <a:endParaRPr lang="en-GB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8" name="ZoneTexte 297"/>
            <p:cNvSpPr txBox="1"/>
            <p:nvPr/>
          </p:nvSpPr>
          <p:spPr>
            <a:xfrm>
              <a:off x="3798000" y="6198850"/>
              <a:ext cx="42223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BE" sz="8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24%</a:t>
              </a:r>
              <a:endParaRPr lang="en-GB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9" name="ZoneTexte 298"/>
            <p:cNvSpPr txBox="1"/>
            <p:nvPr/>
          </p:nvSpPr>
          <p:spPr>
            <a:xfrm>
              <a:off x="3734500" y="7572424"/>
              <a:ext cx="42223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BE" sz="8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1%</a:t>
              </a:r>
              <a:endParaRPr lang="en-GB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0" name="ZoneTexte 299"/>
            <p:cNvSpPr txBox="1"/>
            <p:nvPr/>
          </p:nvSpPr>
          <p:spPr>
            <a:xfrm>
              <a:off x="5461200" y="4956850"/>
              <a:ext cx="42223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BE" sz="8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75%</a:t>
              </a:r>
              <a:endParaRPr lang="en-GB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7" name="ZoneTexte 306"/>
            <p:cNvSpPr txBox="1"/>
            <p:nvPr/>
          </p:nvSpPr>
          <p:spPr>
            <a:xfrm>
              <a:off x="5461200" y="6198849"/>
              <a:ext cx="42223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BE" sz="8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25%</a:t>
              </a:r>
              <a:endParaRPr lang="en-GB" sz="8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8" name="ZoneTexte 307">
              <a:extLst>
                <a:ext uri="{FF2B5EF4-FFF2-40B4-BE49-F238E27FC236}">
                  <a16:creationId xmlns:a16="http://schemas.microsoft.com/office/drawing/2014/main" id="{06763897-9391-4AD3-A1A9-709A96241C1C}"/>
                </a:ext>
              </a:extLst>
            </p:cNvPr>
            <p:cNvSpPr txBox="1"/>
            <p:nvPr/>
          </p:nvSpPr>
          <p:spPr>
            <a:xfrm>
              <a:off x="3045778" y="4026396"/>
              <a:ext cx="28800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’</a:t>
              </a:r>
            </a:p>
          </p:txBody>
        </p:sp>
        <p:sp>
          <p:nvSpPr>
            <p:cNvPr id="317" name="ZoneTexte 316">
              <a:extLst>
                <a:ext uri="{FF2B5EF4-FFF2-40B4-BE49-F238E27FC236}">
                  <a16:creationId xmlns:a16="http://schemas.microsoft.com/office/drawing/2014/main" id="{B38EDDC2-19AF-436D-B1CA-9AAD680188EC}"/>
                </a:ext>
              </a:extLst>
            </p:cNvPr>
            <p:cNvSpPr txBox="1"/>
            <p:nvPr/>
          </p:nvSpPr>
          <p:spPr>
            <a:xfrm>
              <a:off x="3045778" y="4630454"/>
              <a:ext cx="28800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’</a:t>
              </a:r>
            </a:p>
          </p:txBody>
        </p:sp>
        <p:sp>
          <p:nvSpPr>
            <p:cNvPr id="320" name="ZoneTexte 319">
              <a:extLst>
                <a:ext uri="{FF2B5EF4-FFF2-40B4-BE49-F238E27FC236}">
                  <a16:creationId xmlns:a16="http://schemas.microsoft.com/office/drawing/2014/main" id="{A307784B-A5D0-4D31-B2F5-CF3B182CBCD3}"/>
                </a:ext>
              </a:extLst>
            </p:cNvPr>
            <p:cNvSpPr txBox="1"/>
            <p:nvPr/>
          </p:nvSpPr>
          <p:spPr>
            <a:xfrm>
              <a:off x="3045778" y="5260698"/>
              <a:ext cx="28800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’</a:t>
              </a:r>
            </a:p>
          </p:txBody>
        </p:sp>
        <p:sp>
          <p:nvSpPr>
            <p:cNvPr id="323" name="ZoneTexte 322">
              <a:extLst>
                <a:ext uri="{FF2B5EF4-FFF2-40B4-BE49-F238E27FC236}">
                  <a16:creationId xmlns:a16="http://schemas.microsoft.com/office/drawing/2014/main" id="{3BF7E02C-7BE3-43E9-96BB-7A1CE6ED11FB}"/>
                </a:ext>
              </a:extLst>
            </p:cNvPr>
            <p:cNvSpPr txBox="1"/>
            <p:nvPr/>
          </p:nvSpPr>
          <p:spPr>
            <a:xfrm>
              <a:off x="3045778" y="5877849"/>
              <a:ext cx="28800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’</a:t>
              </a:r>
            </a:p>
          </p:txBody>
        </p:sp>
        <p:sp>
          <p:nvSpPr>
            <p:cNvPr id="325" name="ZoneTexte 324">
              <a:extLst>
                <a:ext uri="{FF2B5EF4-FFF2-40B4-BE49-F238E27FC236}">
                  <a16:creationId xmlns:a16="http://schemas.microsoft.com/office/drawing/2014/main" id="{0934A3FB-B34F-4D18-993E-492E0079184B}"/>
                </a:ext>
              </a:extLst>
            </p:cNvPr>
            <p:cNvSpPr txBox="1"/>
            <p:nvPr/>
          </p:nvSpPr>
          <p:spPr>
            <a:xfrm>
              <a:off x="3045778" y="6507860"/>
              <a:ext cx="28800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BE" sz="7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’</a:t>
              </a:r>
              <a:endParaRPr lang="en-US" sz="7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7" name="ZoneTexte 326">
              <a:extLst>
                <a:ext uri="{FF2B5EF4-FFF2-40B4-BE49-F238E27FC236}">
                  <a16:creationId xmlns:a16="http://schemas.microsoft.com/office/drawing/2014/main" id="{E770A8E2-CEEA-49FC-BAD5-71D372C1704C}"/>
                </a:ext>
              </a:extLst>
            </p:cNvPr>
            <p:cNvSpPr txBox="1"/>
            <p:nvPr/>
          </p:nvSpPr>
          <p:spPr>
            <a:xfrm>
              <a:off x="3045778" y="7112151"/>
              <a:ext cx="28800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’</a:t>
              </a:r>
            </a:p>
          </p:txBody>
        </p:sp>
        <p:sp>
          <p:nvSpPr>
            <p:cNvPr id="329" name="ZoneTexte 328">
              <a:extLst>
                <a:ext uri="{FF2B5EF4-FFF2-40B4-BE49-F238E27FC236}">
                  <a16:creationId xmlns:a16="http://schemas.microsoft.com/office/drawing/2014/main" id="{14B32C0A-DC95-41A2-AA7C-FB4C3E4061B6}"/>
                </a:ext>
              </a:extLst>
            </p:cNvPr>
            <p:cNvSpPr txBox="1"/>
            <p:nvPr/>
          </p:nvSpPr>
          <p:spPr>
            <a:xfrm>
              <a:off x="5452371" y="4022060"/>
              <a:ext cx="28800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’’</a:t>
              </a:r>
            </a:p>
          </p:txBody>
        </p:sp>
        <p:sp>
          <p:nvSpPr>
            <p:cNvPr id="330" name="ZoneTexte 329">
              <a:extLst>
                <a:ext uri="{FF2B5EF4-FFF2-40B4-BE49-F238E27FC236}">
                  <a16:creationId xmlns:a16="http://schemas.microsoft.com/office/drawing/2014/main" id="{24EA8D83-99E3-46E3-83B5-76056C5F0F4E}"/>
                </a:ext>
              </a:extLst>
            </p:cNvPr>
            <p:cNvSpPr txBox="1"/>
            <p:nvPr/>
          </p:nvSpPr>
          <p:spPr>
            <a:xfrm>
              <a:off x="5452371" y="4626551"/>
              <a:ext cx="28800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’’</a:t>
              </a:r>
            </a:p>
          </p:txBody>
        </p:sp>
        <p:sp>
          <p:nvSpPr>
            <p:cNvPr id="331" name="ZoneTexte 330">
              <a:extLst>
                <a:ext uri="{FF2B5EF4-FFF2-40B4-BE49-F238E27FC236}">
                  <a16:creationId xmlns:a16="http://schemas.microsoft.com/office/drawing/2014/main" id="{483D35D4-C443-475B-B861-E8C43B289260}"/>
                </a:ext>
              </a:extLst>
            </p:cNvPr>
            <p:cNvSpPr txBox="1"/>
            <p:nvPr/>
          </p:nvSpPr>
          <p:spPr>
            <a:xfrm>
              <a:off x="5458303" y="5265820"/>
              <a:ext cx="28800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’’</a:t>
              </a:r>
            </a:p>
          </p:txBody>
        </p:sp>
        <p:sp>
          <p:nvSpPr>
            <p:cNvPr id="332" name="ZoneTexte 331">
              <a:extLst>
                <a:ext uri="{FF2B5EF4-FFF2-40B4-BE49-F238E27FC236}">
                  <a16:creationId xmlns:a16="http://schemas.microsoft.com/office/drawing/2014/main" id="{EAB90309-D356-4413-A133-D78128AEE722}"/>
                </a:ext>
              </a:extLst>
            </p:cNvPr>
            <p:cNvSpPr txBox="1"/>
            <p:nvPr/>
          </p:nvSpPr>
          <p:spPr>
            <a:xfrm>
              <a:off x="5450905" y="5867145"/>
              <a:ext cx="28800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’’</a:t>
              </a:r>
            </a:p>
          </p:txBody>
        </p:sp>
        <p:sp>
          <p:nvSpPr>
            <p:cNvPr id="335" name="ZoneTexte 334">
              <a:extLst>
                <a:ext uri="{FF2B5EF4-FFF2-40B4-BE49-F238E27FC236}">
                  <a16:creationId xmlns:a16="http://schemas.microsoft.com/office/drawing/2014/main" id="{AFBF1F5B-A7E1-48F9-BC0A-5FCF7892B0E6}"/>
                </a:ext>
              </a:extLst>
            </p:cNvPr>
            <p:cNvSpPr txBox="1"/>
            <p:nvPr/>
          </p:nvSpPr>
          <p:spPr>
            <a:xfrm>
              <a:off x="4710874" y="4022494"/>
              <a:ext cx="28800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’’</a:t>
              </a:r>
            </a:p>
          </p:txBody>
        </p:sp>
        <p:sp>
          <p:nvSpPr>
            <p:cNvPr id="336" name="ZoneTexte 335">
              <a:extLst>
                <a:ext uri="{FF2B5EF4-FFF2-40B4-BE49-F238E27FC236}">
                  <a16:creationId xmlns:a16="http://schemas.microsoft.com/office/drawing/2014/main" id="{6E1911E4-2AE2-4E96-8380-27BC9BEC2FDB}"/>
                </a:ext>
              </a:extLst>
            </p:cNvPr>
            <p:cNvSpPr txBox="1"/>
            <p:nvPr/>
          </p:nvSpPr>
          <p:spPr>
            <a:xfrm>
              <a:off x="4710874" y="4626552"/>
              <a:ext cx="28800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’’</a:t>
              </a:r>
            </a:p>
          </p:txBody>
        </p:sp>
        <p:sp>
          <p:nvSpPr>
            <p:cNvPr id="337" name="ZoneTexte 336">
              <a:extLst>
                <a:ext uri="{FF2B5EF4-FFF2-40B4-BE49-F238E27FC236}">
                  <a16:creationId xmlns:a16="http://schemas.microsoft.com/office/drawing/2014/main" id="{DCE492EF-6ACE-4FA1-B108-D345D23F5B30}"/>
                </a:ext>
              </a:extLst>
            </p:cNvPr>
            <p:cNvSpPr txBox="1"/>
            <p:nvPr/>
          </p:nvSpPr>
          <p:spPr>
            <a:xfrm>
              <a:off x="4710874" y="5261259"/>
              <a:ext cx="28800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’’</a:t>
              </a:r>
            </a:p>
          </p:txBody>
        </p:sp>
        <p:sp>
          <p:nvSpPr>
            <p:cNvPr id="338" name="ZoneTexte 337">
              <a:extLst>
                <a:ext uri="{FF2B5EF4-FFF2-40B4-BE49-F238E27FC236}">
                  <a16:creationId xmlns:a16="http://schemas.microsoft.com/office/drawing/2014/main" id="{80EF1314-175D-4CB8-B52F-9C2B707EC625}"/>
                </a:ext>
              </a:extLst>
            </p:cNvPr>
            <p:cNvSpPr txBox="1"/>
            <p:nvPr/>
          </p:nvSpPr>
          <p:spPr>
            <a:xfrm>
              <a:off x="4710874" y="5874221"/>
              <a:ext cx="28800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’’</a:t>
              </a:r>
            </a:p>
          </p:txBody>
        </p:sp>
      </p:grpSp>
      <p:sp>
        <p:nvSpPr>
          <p:cNvPr id="333" name="ZoneTexte 30">
            <a:extLst>
              <a:ext uri="{FF2B5EF4-FFF2-40B4-BE49-F238E27FC236}">
                <a16:creationId xmlns:a16="http://schemas.microsoft.com/office/drawing/2014/main" id="{833B01A9-40D3-4D31-87F8-0B848BE38BD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1384" y="149471"/>
            <a:ext cx="137417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4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Figure S1</a:t>
            </a:r>
            <a:endParaRPr kumimoji="0" lang="fr-FR" altLang="fr-FR" sz="1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5268225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127</TotalTime>
  <Words>223</Words>
  <Application>Microsoft Office PowerPoint</Application>
  <PresentationFormat>Affichage à l'écran (4:3)</PresentationFormat>
  <Paragraphs>118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2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4" baseType="lpstr">
      <vt:lpstr>Arial</vt:lpstr>
      <vt:lpstr>Calibri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orvan Léa</dc:creator>
  <cp:lastModifiedBy>Alain Vanderplasschen</cp:lastModifiedBy>
  <cp:revision>115</cp:revision>
  <dcterms:created xsi:type="dcterms:W3CDTF">2019-01-18T12:58:39Z</dcterms:created>
  <dcterms:modified xsi:type="dcterms:W3CDTF">2022-07-05T07:56:09Z</dcterms:modified>
</cp:coreProperties>
</file>